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5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DB98570-8C3B-4D46-9CDF-04B3B4C8977F}" v="17" dt="2021-11-26T10:27:03.1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545" autoAdjust="0"/>
    <p:restoredTop sz="94912" autoAdjust="0"/>
  </p:normalViewPr>
  <p:slideViewPr>
    <p:cSldViewPr snapToGrid="0" showGuides="1">
      <p:cViewPr>
        <p:scale>
          <a:sx n="60" d="100"/>
          <a:sy n="60" d="100"/>
        </p:scale>
        <p:origin x="2372" y="28"/>
      </p:cViewPr>
      <p:guideLst>
        <p:guide orient="horz" pos="3143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ucia Pedicini" userId="5525d782-bff0-43e0-ac01-65707fcdbdc6" providerId="ADAL" clId="{4EF33EA4-6D56-41E9-98F5-3CF96A6C152C}"/>
    <pc:docChg chg="custSel addSld modSld">
      <pc:chgData name="Lucia Pedicini" userId="5525d782-bff0-43e0-ac01-65707fcdbdc6" providerId="ADAL" clId="{4EF33EA4-6D56-41E9-98F5-3CF96A6C152C}" dt="2021-10-08T12:52:43.644" v="740"/>
      <pc:docMkLst>
        <pc:docMk/>
      </pc:docMkLst>
      <pc:sldChg chg="addSp delSp modSp mod">
        <pc:chgData name="Lucia Pedicini" userId="5525d782-bff0-43e0-ac01-65707fcdbdc6" providerId="ADAL" clId="{4EF33EA4-6D56-41E9-98F5-3CF96A6C152C}" dt="2021-10-08T12:36:18.018" v="467" actId="1037"/>
        <pc:sldMkLst>
          <pc:docMk/>
          <pc:sldMk cId="3716345386" sldId="256"/>
        </pc:sldMkLst>
        <pc:spChg chg="mod">
          <ac:chgData name="Lucia Pedicini" userId="5525d782-bff0-43e0-ac01-65707fcdbdc6" providerId="ADAL" clId="{4EF33EA4-6D56-41E9-98F5-3CF96A6C152C}" dt="2021-10-08T10:30:57.252" v="4" actId="1076"/>
          <ac:spMkLst>
            <pc:docMk/>
            <pc:sldMk cId="3716345386" sldId="256"/>
            <ac:spMk id="19" creationId="{BD788286-F91D-4CE6-B828-DA226C33BD60}"/>
          </ac:spMkLst>
        </pc:spChg>
        <pc:spChg chg="mod">
          <ac:chgData name="Lucia Pedicini" userId="5525d782-bff0-43e0-ac01-65707fcdbdc6" providerId="ADAL" clId="{4EF33EA4-6D56-41E9-98F5-3CF96A6C152C}" dt="2021-10-08T10:29:23.097" v="1"/>
          <ac:spMkLst>
            <pc:docMk/>
            <pc:sldMk cId="3716345386" sldId="256"/>
            <ac:spMk id="21" creationId="{71766B27-336A-4537-9027-1B6B95C5218F}"/>
          </ac:spMkLst>
        </pc:spChg>
        <pc:spChg chg="mod">
          <ac:chgData name="Lucia Pedicini" userId="5525d782-bff0-43e0-ac01-65707fcdbdc6" providerId="ADAL" clId="{4EF33EA4-6D56-41E9-98F5-3CF96A6C152C}" dt="2021-10-08T10:29:23.097" v="1"/>
          <ac:spMkLst>
            <pc:docMk/>
            <pc:sldMk cId="3716345386" sldId="256"/>
            <ac:spMk id="22" creationId="{75C51B56-AA10-4AA7-881C-91FEF508D867}"/>
          </ac:spMkLst>
        </pc:spChg>
        <pc:spChg chg="mod">
          <ac:chgData name="Lucia Pedicini" userId="5525d782-bff0-43e0-ac01-65707fcdbdc6" providerId="ADAL" clId="{4EF33EA4-6D56-41E9-98F5-3CF96A6C152C}" dt="2021-10-08T10:29:23.097" v="1"/>
          <ac:spMkLst>
            <pc:docMk/>
            <pc:sldMk cId="3716345386" sldId="256"/>
            <ac:spMk id="26" creationId="{905EBA9B-7C02-4306-BE88-FCB9225F7C79}"/>
          </ac:spMkLst>
        </pc:spChg>
        <pc:spChg chg="mod">
          <ac:chgData name="Lucia Pedicini" userId="5525d782-bff0-43e0-ac01-65707fcdbdc6" providerId="ADAL" clId="{4EF33EA4-6D56-41E9-98F5-3CF96A6C152C}" dt="2021-10-08T10:29:23.097" v="1"/>
          <ac:spMkLst>
            <pc:docMk/>
            <pc:sldMk cId="3716345386" sldId="256"/>
            <ac:spMk id="27" creationId="{BD8BDEF3-F1C9-46C9-9138-9ED95374A886}"/>
          </ac:spMkLst>
        </pc:spChg>
        <pc:spChg chg="mod">
          <ac:chgData name="Lucia Pedicini" userId="5525d782-bff0-43e0-ac01-65707fcdbdc6" providerId="ADAL" clId="{4EF33EA4-6D56-41E9-98F5-3CF96A6C152C}" dt="2021-10-08T10:29:23.097" v="1"/>
          <ac:spMkLst>
            <pc:docMk/>
            <pc:sldMk cId="3716345386" sldId="256"/>
            <ac:spMk id="28" creationId="{B59F5760-D32A-4E10-AB64-A06EDB6C50F4}"/>
          </ac:spMkLst>
        </pc:spChg>
        <pc:spChg chg="mod">
          <ac:chgData name="Lucia Pedicini" userId="5525d782-bff0-43e0-ac01-65707fcdbdc6" providerId="ADAL" clId="{4EF33EA4-6D56-41E9-98F5-3CF96A6C152C}" dt="2021-10-08T10:29:23.097" v="1"/>
          <ac:spMkLst>
            <pc:docMk/>
            <pc:sldMk cId="3716345386" sldId="256"/>
            <ac:spMk id="29" creationId="{F5F9BA83-F597-4714-9B1F-AA7749467F81}"/>
          </ac:spMkLst>
        </pc:spChg>
        <pc:spChg chg="add mod">
          <ac:chgData name="Lucia Pedicini" userId="5525d782-bff0-43e0-ac01-65707fcdbdc6" providerId="ADAL" clId="{4EF33EA4-6D56-41E9-98F5-3CF96A6C152C}" dt="2021-10-08T10:31:10.464" v="8" actId="20577"/>
          <ac:spMkLst>
            <pc:docMk/>
            <pc:sldMk cId="3716345386" sldId="256"/>
            <ac:spMk id="32" creationId="{65D1F826-5A35-4663-9651-E5E78EFF9FAB}"/>
          </ac:spMkLst>
        </pc:spChg>
        <pc:spChg chg="add mod">
          <ac:chgData name="Lucia Pedicini" userId="5525d782-bff0-43e0-ac01-65707fcdbdc6" providerId="ADAL" clId="{4EF33EA4-6D56-41E9-98F5-3CF96A6C152C}" dt="2021-10-08T12:35:30.561" v="396" actId="1076"/>
          <ac:spMkLst>
            <pc:docMk/>
            <pc:sldMk cId="3716345386" sldId="256"/>
            <ac:spMk id="36" creationId="{DAE621AE-4996-445F-9308-D7F5F18CED06}"/>
          </ac:spMkLst>
        </pc:spChg>
        <pc:spChg chg="add mod">
          <ac:chgData name="Lucia Pedicini" userId="5525d782-bff0-43e0-ac01-65707fcdbdc6" providerId="ADAL" clId="{4EF33EA4-6D56-41E9-98F5-3CF96A6C152C}" dt="2021-10-08T12:35:52.512" v="400" actId="1076"/>
          <ac:spMkLst>
            <pc:docMk/>
            <pc:sldMk cId="3716345386" sldId="256"/>
            <ac:spMk id="37" creationId="{C8622D86-A4DA-45F9-9F6E-6D55E8BB0D6E}"/>
          </ac:spMkLst>
        </pc:spChg>
        <pc:spChg chg="add mod">
          <ac:chgData name="Lucia Pedicini" userId="5525d782-bff0-43e0-ac01-65707fcdbdc6" providerId="ADAL" clId="{4EF33EA4-6D56-41E9-98F5-3CF96A6C152C}" dt="2021-10-08T12:36:18.018" v="467" actId="1037"/>
          <ac:spMkLst>
            <pc:docMk/>
            <pc:sldMk cId="3716345386" sldId="256"/>
            <ac:spMk id="38" creationId="{A3F2E2F3-DA73-4813-8E3F-B780B117BF52}"/>
          </ac:spMkLst>
        </pc:spChg>
        <pc:spChg chg="add mod">
          <ac:chgData name="Lucia Pedicini" userId="5525d782-bff0-43e0-ac01-65707fcdbdc6" providerId="ADAL" clId="{4EF33EA4-6D56-41E9-98F5-3CF96A6C152C}" dt="2021-10-08T12:36:18.018" v="467" actId="1037"/>
          <ac:spMkLst>
            <pc:docMk/>
            <pc:sldMk cId="3716345386" sldId="256"/>
            <ac:spMk id="39" creationId="{8BFE5FF1-6B6F-4993-B244-03859D1970C0}"/>
          </ac:spMkLst>
        </pc:spChg>
        <pc:spChg chg="del mod">
          <ac:chgData name="Lucia Pedicini" userId="5525d782-bff0-43e0-ac01-65707fcdbdc6" providerId="ADAL" clId="{4EF33EA4-6D56-41E9-98F5-3CF96A6C152C}" dt="2021-10-08T10:40:54.140" v="72" actId="478"/>
          <ac:spMkLst>
            <pc:docMk/>
            <pc:sldMk cId="3716345386" sldId="256"/>
            <ac:spMk id="44" creationId="{A7CAEFC6-FAC5-4885-AA6D-5FB64FA54100}"/>
          </ac:spMkLst>
        </pc:spChg>
        <pc:spChg chg="mod">
          <ac:chgData name="Lucia Pedicini" userId="5525d782-bff0-43e0-ac01-65707fcdbdc6" providerId="ADAL" clId="{4EF33EA4-6D56-41E9-98F5-3CF96A6C152C}" dt="2021-10-08T10:45:32.873" v="92"/>
          <ac:spMkLst>
            <pc:docMk/>
            <pc:sldMk cId="3716345386" sldId="256"/>
            <ac:spMk id="48" creationId="{B352548F-C508-4683-80B1-3E6805D1EE66}"/>
          </ac:spMkLst>
        </pc:spChg>
        <pc:spChg chg="add del mod">
          <ac:chgData name="Lucia Pedicini" userId="5525d782-bff0-43e0-ac01-65707fcdbdc6" providerId="ADAL" clId="{4EF33EA4-6D56-41E9-98F5-3CF96A6C152C}" dt="2021-10-08T10:45:57.999" v="98" actId="478"/>
          <ac:spMkLst>
            <pc:docMk/>
            <pc:sldMk cId="3716345386" sldId="256"/>
            <ac:spMk id="49" creationId="{6BCC291C-7151-4C06-9FCD-4A84297C50F9}"/>
          </ac:spMkLst>
        </pc:spChg>
        <pc:grpChg chg="add mod">
          <ac:chgData name="Lucia Pedicini" userId="5525d782-bff0-43e0-ac01-65707fcdbdc6" providerId="ADAL" clId="{4EF33EA4-6D56-41E9-98F5-3CF96A6C152C}" dt="2021-10-08T10:29:44" v="3" actId="1076"/>
          <ac:grpSpMkLst>
            <pc:docMk/>
            <pc:sldMk cId="3716345386" sldId="256"/>
            <ac:grpSpMk id="20" creationId="{29DD0701-0926-41CE-8E2B-217E10F4FC32}"/>
          </ac:grpSpMkLst>
        </pc:grpChg>
        <pc:grpChg chg="mod">
          <ac:chgData name="Lucia Pedicini" userId="5525d782-bff0-43e0-ac01-65707fcdbdc6" providerId="ADAL" clId="{4EF33EA4-6D56-41E9-98F5-3CF96A6C152C}" dt="2021-10-08T10:29:23.097" v="1"/>
          <ac:grpSpMkLst>
            <pc:docMk/>
            <pc:sldMk cId="3716345386" sldId="256"/>
            <ac:grpSpMk id="23" creationId="{ACB89250-0CE5-49FD-84B1-4AE85F609FB1}"/>
          </ac:grpSpMkLst>
        </pc:grpChg>
        <pc:grpChg chg="add mod">
          <ac:chgData name="Lucia Pedicini" userId="5525d782-bff0-43e0-ac01-65707fcdbdc6" providerId="ADAL" clId="{4EF33EA4-6D56-41E9-98F5-3CF96A6C152C}" dt="2021-10-08T12:36:18.018" v="467" actId="1037"/>
          <ac:grpSpMkLst>
            <pc:docMk/>
            <pc:sldMk cId="3716345386" sldId="256"/>
            <ac:grpSpMk id="41" creationId="{21EF2343-9170-4D0E-B0FC-5286A665A39B}"/>
          </ac:grpSpMkLst>
        </pc:grpChg>
        <pc:grpChg chg="add del mod">
          <ac:chgData name="Lucia Pedicini" userId="5525d782-bff0-43e0-ac01-65707fcdbdc6" providerId="ADAL" clId="{4EF33EA4-6D56-41E9-98F5-3CF96A6C152C}" dt="2021-10-08T10:45:37.151" v="94" actId="478"/>
          <ac:grpSpMkLst>
            <pc:docMk/>
            <pc:sldMk cId="3716345386" sldId="256"/>
            <ac:grpSpMk id="45" creationId="{8F800800-FB49-4FB6-B61C-B262603893F8}"/>
          </ac:grpSpMkLst>
        </pc:grpChg>
        <pc:graphicFrameChg chg="del mod">
          <ac:chgData name="Lucia Pedicini" userId="5525d782-bff0-43e0-ac01-65707fcdbdc6" providerId="ADAL" clId="{4EF33EA4-6D56-41E9-98F5-3CF96A6C152C}" dt="2021-10-08T12:35:05.773" v="392" actId="478"/>
          <ac:graphicFrameMkLst>
            <pc:docMk/>
            <pc:sldMk cId="3716345386" sldId="256"/>
            <ac:graphicFrameMk id="4" creationId="{5D883083-282F-4617-8367-CBFD0E662429}"/>
          </ac:graphicFrameMkLst>
        </pc:graphicFrameChg>
        <pc:graphicFrameChg chg="mod">
          <ac:chgData name="Lucia Pedicini" userId="5525d782-bff0-43e0-ac01-65707fcdbdc6" providerId="ADAL" clId="{4EF33EA4-6D56-41E9-98F5-3CF96A6C152C}" dt="2021-10-08T10:24:10.453" v="0"/>
          <ac:graphicFrameMkLst>
            <pc:docMk/>
            <pc:sldMk cId="3716345386" sldId="256"/>
            <ac:graphicFrameMk id="7" creationId="{9FF49640-7DC7-4722-9B25-070FEA408A8B}"/>
          </ac:graphicFrameMkLst>
        </pc:graphicFrameChg>
        <pc:graphicFrameChg chg="add mod">
          <ac:chgData name="Lucia Pedicini" userId="5525d782-bff0-43e0-ac01-65707fcdbdc6" providerId="ADAL" clId="{4EF33EA4-6D56-41E9-98F5-3CF96A6C152C}" dt="2021-10-08T12:36:18.018" v="467" actId="1037"/>
          <ac:graphicFrameMkLst>
            <pc:docMk/>
            <pc:sldMk cId="3716345386" sldId="256"/>
            <ac:graphicFrameMk id="34" creationId="{FD26E46E-93E8-45BA-A98E-9BA87DA2DF62}"/>
          </ac:graphicFrameMkLst>
        </pc:graphicFrameChg>
        <pc:graphicFrameChg chg="add mod">
          <ac:chgData name="Lucia Pedicini" userId="5525d782-bff0-43e0-ac01-65707fcdbdc6" providerId="ADAL" clId="{4EF33EA4-6D56-41E9-98F5-3CF96A6C152C}" dt="2021-10-08T12:36:18.018" v="467" actId="1037"/>
          <ac:graphicFrameMkLst>
            <pc:docMk/>
            <pc:sldMk cId="3716345386" sldId="256"/>
            <ac:graphicFrameMk id="35" creationId="{42890443-431C-4F2C-93A1-8BC272916BA4}"/>
          </ac:graphicFrameMkLst>
        </pc:graphicFrameChg>
        <pc:graphicFrameChg chg="add mod">
          <ac:chgData name="Lucia Pedicini" userId="5525d782-bff0-43e0-ac01-65707fcdbdc6" providerId="ADAL" clId="{4EF33EA4-6D56-41E9-98F5-3CF96A6C152C}" dt="2021-10-08T12:36:18.018" v="467" actId="1037"/>
          <ac:graphicFrameMkLst>
            <pc:docMk/>
            <pc:sldMk cId="3716345386" sldId="256"/>
            <ac:graphicFrameMk id="40" creationId="{FC6A20ED-0757-4AC1-8222-8C026578F68E}"/>
          </ac:graphicFrameMkLst>
        </pc:graphicFrameChg>
        <pc:graphicFrameChg chg="mod">
          <ac:chgData name="Lucia Pedicini" userId="5525d782-bff0-43e0-ac01-65707fcdbdc6" providerId="ADAL" clId="{4EF33EA4-6D56-41E9-98F5-3CF96A6C152C}" dt="2021-10-08T12:36:06.408" v="402" actId="1076"/>
          <ac:graphicFrameMkLst>
            <pc:docMk/>
            <pc:sldMk cId="3716345386" sldId="256"/>
            <ac:graphicFrameMk id="42" creationId="{01F60C8C-88B0-4E69-A16B-46E33B1028B9}"/>
          </ac:graphicFrameMkLst>
        </pc:graphicFrameChg>
        <pc:graphicFrameChg chg="mod">
          <ac:chgData name="Lucia Pedicini" userId="5525d782-bff0-43e0-ac01-65707fcdbdc6" providerId="ADAL" clId="{4EF33EA4-6D56-41E9-98F5-3CF96A6C152C}" dt="2021-10-08T10:45:34.608" v="93" actId="1076"/>
          <ac:graphicFrameMkLst>
            <pc:docMk/>
            <pc:sldMk cId="3716345386" sldId="256"/>
            <ac:graphicFrameMk id="46" creationId="{F4BE81EB-9EC7-4E32-AFC1-2D8969CF5770}"/>
          </ac:graphicFrameMkLst>
        </pc:graphicFrameChg>
        <pc:picChg chg="mod">
          <ac:chgData name="Lucia Pedicini" userId="5525d782-bff0-43e0-ac01-65707fcdbdc6" providerId="ADAL" clId="{4EF33EA4-6D56-41E9-98F5-3CF96A6C152C}" dt="2021-10-08T10:29:23.097" v="1"/>
          <ac:picMkLst>
            <pc:docMk/>
            <pc:sldMk cId="3716345386" sldId="256"/>
            <ac:picMk id="24" creationId="{B744AE2B-8C81-42BE-9509-27747E4EECC2}"/>
          </ac:picMkLst>
        </pc:picChg>
        <pc:picChg chg="mod">
          <ac:chgData name="Lucia Pedicini" userId="5525d782-bff0-43e0-ac01-65707fcdbdc6" providerId="ADAL" clId="{4EF33EA4-6D56-41E9-98F5-3CF96A6C152C}" dt="2021-10-08T10:29:23.097" v="1"/>
          <ac:picMkLst>
            <pc:docMk/>
            <pc:sldMk cId="3716345386" sldId="256"/>
            <ac:picMk id="25" creationId="{80CD5D59-1B44-4334-B978-2D62F3DFBAAE}"/>
          </ac:picMkLst>
        </pc:picChg>
        <pc:picChg chg="mod">
          <ac:chgData name="Lucia Pedicini" userId="5525d782-bff0-43e0-ac01-65707fcdbdc6" providerId="ADAL" clId="{4EF33EA4-6D56-41E9-98F5-3CF96A6C152C}" dt="2021-10-08T10:29:23.097" v="1"/>
          <ac:picMkLst>
            <pc:docMk/>
            <pc:sldMk cId="3716345386" sldId="256"/>
            <ac:picMk id="30" creationId="{6002B7CA-FBCD-4E72-963A-E2B5AC4D2D5B}"/>
          </ac:picMkLst>
        </pc:picChg>
        <pc:picChg chg="mod">
          <ac:chgData name="Lucia Pedicini" userId="5525d782-bff0-43e0-ac01-65707fcdbdc6" providerId="ADAL" clId="{4EF33EA4-6D56-41E9-98F5-3CF96A6C152C}" dt="2021-10-08T10:29:23.097" v="1"/>
          <ac:picMkLst>
            <pc:docMk/>
            <pc:sldMk cId="3716345386" sldId="256"/>
            <ac:picMk id="31" creationId="{C51C1B8B-8650-4873-B83F-A8B539C66D4A}"/>
          </ac:picMkLst>
        </pc:picChg>
        <pc:picChg chg="add mod modCrop">
          <ac:chgData name="Lucia Pedicini" userId="5525d782-bff0-43e0-ac01-65707fcdbdc6" providerId="ADAL" clId="{4EF33EA4-6D56-41E9-98F5-3CF96A6C152C}" dt="2021-10-08T12:35:39.260" v="397" actId="1076"/>
          <ac:picMkLst>
            <pc:docMk/>
            <pc:sldMk cId="3716345386" sldId="256"/>
            <ac:picMk id="33" creationId="{5CEEE964-E118-4EE6-A078-00D652DD68EC}"/>
          </ac:picMkLst>
        </pc:picChg>
        <pc:picChg chg="add mod modCrop">
          <ac:chgData name="Lucia Pedicini" userId="5525d782-bff0-43e0-ac01-65707fcdbdc6" providerId="ADAL" clId="{4EF33EA4-6D56-41E9-98F5-3CF96A6C152C}" dt="2021-10-08T12:35:46.871" v="399" actId="14100"/>
          <ac:picMkLst>
            <pc:docMk/>
            <pc:sldMk cId="3716345386" sldId="256"/>
            <ac:picMk id="50" creationId="{0EDF276C-97E5-4D77-9D3A-3C7D1C4B58D5}"/>
          </ac:picMkLst>
        </pc:picChg>
        <pc:cxnChg chg="mod">
          <ac:chgData name="Lucia Pedicini" userId="5525d782-bff0-43e0-ac01-65707fcdbdc6" providerId="ADAL" clId="{4EF33EA4-6D56-41E9-98F5-3CF96A6C152C}" dt="2021-10-08T10:41:52.449" v="87" actId="14100"/>
          <ac:cxnSpMkLst>
            <pc:docMk/>
            <pc:sldMk cId="3716345386" sldId="256"/>
            <ac:cxnSpMk id="43" creationId="{8635B1B8-351A-4F17-80DD-6E0960DCC6CF}"/>
          </ac:cxnSpMkLst>
        </pc:cxnChg>
        <pc:cxnChg chg="mod">
          <ac:chgData name="Lucia Pedicini" userId="5525d782-bff0-43e0-ac01-65707fcdbdc6" providerId="ADAL" clId="{4EF33EA4-6D56-41E9-98F5-3CF96A6C152C}" dt="2021-10-08T10:45:32.873" v="92"/>
          <ac:cxnSpMkLst>
            <pc:docMk/>
            <pc:sldMk cId="3716345386" sldId="256"/>
            <ac:cxnSpMk id="47" creationId="{FD8EA7C8-F97C-40E0-9315-A3E7EE929BB6}"/>
          </ac:cxnSpMkLst>
        </pc:cxnChg>
      </pc:sldChg>
      <pc:sldChg chg="addSp delSp modSp add mod modNotesTx">
        <pc:chgData name="Lucia Pedicini" userId="5525d782-bff0-43e0-ac01-65707fcdbdc6" providerId="ADAL" clId="{4EF33EA4-6D56-41E9-98F5-3CF96A6C152C}" dt="2021-10-08T12:52:31.025" v="739" actId="20577"/>
        <pc:sldMkLst>
          <pc:docMk/>
          <pc:sldMk cId="3217791992" sldId="257"/>
        </pc:sldMkLst>
        <pc:spChg chg="add mod">
          <ac:chgData name="Lucia Pedicini" userId="5525d782-bff0-43e0-ac01-65707fcdbdc6" providerId="ADAL" clId="{4EF33EA4-6D56-41E9-98F5-3CF96A6C152C}" dt="2021-10-08T12:41:06.164" v="505" actId="14100"/>
          <ac:spMkLst>
            <pc:docMk/>
            <pc:sldMk cId="3217791992" sldId="257"/>
            <ac:spMk id="2" creationId="{5607D777-C52C-4459-880C-A33B232A04FA}"/>
          </ac:spMkLst>
        </pc:spChg>
        <pc:spChg chg="add mod">
          <ac:chgData name="Lucia Pedicini" userId="5525d782-bff0-43e0-ac01-65707fcdbdc6" providerId="ADAL" clId="{4EF33EA4-6D56-41E9-98F5-3CF96A6C152C}" dt="2021-10-08T12:41:01.262" v="504" actId="14100"/>
          <ac:spMkLst>
            <pc:docMk/>
            <pc:sldMk cId="3217791992" sldId="257"/>
            <ac:spMk id="3" creationId="{6533F1A3-BF20-4035-9A44-25541571CD4A}"/>
          </ac:spMkLst>
        </pc:spChg>
        <pc:spChg chg="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16" creationId="{5F525EA3-4DE6-4843-AF7C-7C2108840F24}"/>
          </ac:spMkLst>
        </pc:spChg>
        <pc:spChg chg="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17" creationId="{88AD979F-C3CF-4ECD-AB90-D54C8FB261EE}"/>
          </ac:spMkLst>
        </pc:spChg>
        <pc:spChg chg="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18" creationId="{E06F5CC8-5A56-4EBD-B73A-5501BC02AC58}"/>
          </ac:spMkLst>
        </pc:spChg>
        <pc:spChg chg="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19" creationId="{BD788286-F91D-4CE6-B828-DA226C33BD60}"/>
          </ac:spMkLst>
        </pc:spChg>
        <pc:spChg chg="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32" creationId="{65D1F826-5A35-4663-9651-E5E78EFF9FAB}"/>
          </ac:spMkLst>
        </pc:spChg>
        <pc:spChg chg="mod">
          <ac:chgData name="Lucia Pedicini" userId="5525d782-bff0-43e0-ac01-65707fcdbdc6" providerId="ADAL" clId="{4EF33EA4-6D56-41E9-98F5-3CF96A6C152C}" dt="2021-10-08T12:32:51.354" v="376" actId="1076"/>
          <ac:spMkLst>
            <pc:docMk/>
            <pc:sldMk cId="3217791992" sldId="257"/>
            <ac:spMk id="36" creationId="{DAE621AE-4996-445F-9308-D7F5F18CED06}"/>
          </ac:spMkLst>
        </pc:spChg>
        <pc:spChg chg="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37" creationId="{C8622D86-A4DA-45F9-9F6E-6D55E8BB0D6E}"/>
          </ac:spMkLst>
        </pc:spChg>
        <pc:spChg chg="mod">
          <ac:chgData name="Lucia Pedicini" userId="5525d782-bff0-43e0-ac01-65707fcdbdc6" providerId="ADAL" clId="{4EF33EA4-6D56-41E9-98F5-3CF96A6C152C}" dt="2021-10-08T12:41:12.438" v="506" actId="1076"/>
          <ac:spMkLst>
            <pc:docMk/>
            <pc:sldMk cId="3217791992" sldId="257"/>
            <ac:spMk id="38" creationId="{A3F2E2F3-DA73-4813-8E3F-B780B117BF52}"/>
          </ac:spMkLst>
        </pc:spChg>
        <pc:spChg chg="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39" creationId="{8BFE5FF1-6B6F-4993-B244-03859D1970C0}"/>
          </ac:spMkLst>
        </pc:spChg>
        <pc:spChg chg="add 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44" creationId="{42D3317F-DCD0-4A8A-B0CA-A8DACB416CFD}"/>
          </ac:spMkLst>
        </pc:spChg>
        <pc:spChg chg="add mod">
          <ac:chgData name="Lucia Pedicini" userId="5525d782-bff0-43e0-ac01-65707fcdbdc6" providerId="ADAL" clId="{4EF33EA4-6D56-41E9-98F5-3CF96A6C152C}" dt="2021-10-08T12:32:55.216" v="377" actId="1076"/>
          <ac:spMkLst>
            <pc:docMk/>
            <pc:sldMk cId="3217791992" sldId="257"/>
            <ac:spMk id="49" creationId="{C903109D-1477-4C29-9E13-8C4CEA00C7A4}"/>
          </ac:spMkLst>
        </pc:spChg>
        <pc:spChg chg="add 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51" creationId="{25292889-46CE-46DF-A2D7-02209177AEE7}"/>
          </ac:spMkLst>
        </pc:spChg>
        <pc:spChg chg="add 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52" creationId="{9B2197C4-861B-4C7A-83CF-31B9E48A4B06}"/>
          </ac:spMkLst>
        </pc:spChg>
        <pc:spChg chg="add 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53" creationId="{5386E2DC-DBBE-4E42-8A35-DE74447CAB0E}"/>
          </ac:spMkLst>
        </pc:spChg>
        <pc:spChg chg="add mod">
          <ac:chgData name="Lucia Pedicini" userId="5525d782-bff0-43e0-ac01-65707fcdbdc6" providerId="ADAL" clId="{4EF33EA4-6D56-41E9-98F5-3CF96A6C152C}" dt="2021-10-08T12:32:39.106" v="374" actId="1035"/>
          <ac:spMkLst>
            <pc:docMk/>
            <pc:sldMk cId="3217791992" sldId="257"/>
            <ac:spMk id="54" creationId="{5E2C67C9-C8D2-451A-8A4F-624650C93724}"/>
          </ac:spMkLst>
        </pc:spChg>
        <pc:spChg chg="add mod">
          <ac:chgData name="Lucia Pedicini" userId="5525d782-bff0-43e0-ac01-65707fcdbdc6" providerId="ADAL" clId="{4EF33EA4-6D56-41E9-98F5-3CF96A6C152C}" dt="2021-10-08T12:33:23.497" v="387" actId="20577"/>
          <ac:spMkLst>
            <pc:docMk/>
            <pc:sldMk cId="3217791992" sldId="257"/>
            <ac:spMk id="57" creationId="{9C2766FA-DE6C-4BA0-B5C4-E655555064D0}"/>
          </ac:spMkLst>
        </pc:spChg>
        <pc:grpChg chg="mod">
          <ac:chgData name="Lucia Pedicini" userId="5525d782-bff0-43e0-ac01-65707fcdbdc6" providerId="ADAL" clId="{4EF33EA4-6D56-41E9-98F5-3CF96A6C152C}" dt="2021-10-08T12:32:39.106" v="374" actId="1035"/>
          <ac:grpSpMkLst>
            <pc:docMk/>
            <pc:sldMk cId="3217791992" sldId="257"/>
            <ac:grpSpMk id="20" creationId="{29DD0701-0926-41CE-8E2B-217E10F4FC32}"/>
          </ac:grpSpMkLst>
        </pc:grpChg>
        <pc:grpChg chg="mod">
          <ac:chgData name="Lucia Pedicini" userId="5525d782-bff0-43e0-ac01-65707fcdbdc6" providerId="ADAL" clId="{4EF33EA4-6D56-41E9-98F5-3CF96A6C152C}" dt="2021-10-08T12:32:39.106" v="374" actId="1035"/>
          <ac:grpSpMkLst>
            <pc:docMk/>
            <pc:sldMk cId="3217791992" sldId="257"/>
            <ac:grpSpMk id="41" creationId="{21EF2343-9170-4D0E-B0FC-5286A665A39B}"/>
          </ac:grpSpMkLst>
        </pc:grpChg>
        <pc:graphicFrameChg chg="del mod">
          <ac:chgData name="Lucia Pedicini" userId="5525d782-bff0-43e0-ac01-65707fcdbdc6" providerId="ADAL" clId="{4EF33EA4-6D56-41E9-98F5-3CF96A6C152C}" dt="2021-10-08T12:23:42.684" v="263" actId="478"/>
          <ac:graphicFrameMkLst>
            <pc:docMk/>
            <pc:sldMk cId="3217791992" sldId="257"/>
            <ac:graphicFrameMk id="4" creationId="{5D883083-282F-4617-8367-CBFD0E662429}"/>
          </ac:graphicFrameMkLst>
        </pc:graphicFrameChg>
        <pc:graphicFrameChg chg="mod">
          <ac:chgData name="Lucia Pedicini" userId="5525d782-bff0-43e0-ac01-65707fcdbdc6" providerId="ADAL" clId="{4EF33EA4-6D56-41E9-98F5-3CF96A6C152C}" dt="2021-10-08T12:32:39.106" v="374" actId="1035"/>
          <ac:graphicFrameMkLst>
            <pc:docMk/>
            <pc:sldMk cId="3217791992" sldId="257"/>
            <ac:graphicFrameMk id="6" creationId="{43926E4D-3A83-4D3A-B060-208B59C70CBB}"/>
          </ac:graphicFrameMkLst>
        </pc:graphicFrameChg>
        <pc:graphicFrameChg chg="mod">
          <ac:chgData name="Lucia Pedicini" userId="5525d782-bff0-43e0-ac01-65707fcdbdc6" providerId="ADAL" clId="{4EF33EA4-6D56-41E9-98F5-3CF96A6C152C}" dt="2021-10-08T12:32:39.106" v="374" actId="1035"/>
          <ac:graphicFrameMkLst>
            <pc:docMk/>
            <pc:sldMk cId="3217791992" sldId="257"/>
            <ac:graphicFrameMk id="7" creationId="{9FF49640-7DC7-4722-9B25-070FEA408A8B}"/>
          </ac:graphicFrameMkLst>
        </pc:graphicFrameChg>
        <pc:graphicFrameChg chg="mod">
          <ac:chgData name="Lucia Pedicini" userId="5525d782-bff0-43e0-ac01-65707fcdbdc6" providerId="ADAL" clId="{4EF33EA4-6D56-41E9-98F5-3CF96A6C152C}" dt="2021-10-08T12:32:39.106" v="374" actId="1035"/>
          <ac:graphicFrameMkLst>
            <pc:docMk/>
            <pc:sldMk cId="3217791992" sldId="257"/>
            <ac:graphicFrameMk id="34" creationId="{FD26E46E-93E8-45BA-A98E-9BA87DA2DF62}"/>
          </ac:graphicFrameMkLst>
        </pc:graphicFrameChg>
        <pc:graphicFrameChg chg="mod">
          <ac:chgData name="Lucia Pedicini" userId="5525d782-bff0-43e0-ac01-65707fcdbdc6" providerId="ADAL" clId="{4EF33EA4-6D56-41E9-98F5-3CF96A6C152C}" dt="2021-10-08T12:32:39.106" v="374" actId="1035"/>
          <ac:graphicFrameMkLst>
            <pc:docMk/>
            <pc:sldMk cId="3217791992" sldId="257"/>
            <ac:graphicFrameMk id="35" creationId="{42890443-431C-4F2C-93A1-8BC272916BA4}"/>
          </ac:graphicFrameMkLst>
        </pc:graphicFrameChg>
        <pc:graphicFrameChg chg="mod">
          <ac:chgData name="Lucia Pedicini" userId="5525d782-bff0-43e0-ac01-65707fcdbdc6" providerId="ADAL" clId="{4EF33EA4-6D56-41E9-98F5-3CF96A6C152C}" dt="2021-10-08T12:32:39.106" v="374" actId="1035"/>
          <ac:graphicFrameMkLst>
            <pc:docMk/>
            <pc:sldMk cId="3217791992" sldId="257"/>
            <ac:graphicFrameMk id="40" creationId="{FC6A20ED-0757-4AC1-8222-8C026578F68E}"/>
          </ac:graphicFrameMkLst>
        </pc:graphicFrameChg>
        <pc:graphicFrameChg chg="mod">
          <ac:chgData name="Lucia Pedicini" userId="5525d782-bff0-43e0-ac01-65707fcdbdc6" providerId="ADAL" clId="{4EF33EA4-6D56-41E9-98F5-3CF96A6C152C}" dt="2021-10-08T12:21:18.961" v="218" actId="14100"/>
          <ac:graphicFrameMkLst>
            <pc:docMk/>
            <pc:sldMk cId="3217791992" sldId="257"/>
            <ac:graphicFrameMk id="42" creationId="{01F60C8C-88B0-4E69-A16B-46E33B1028B9}"/>
          </ac:graphicFrameMkLst>
        </pc:graphicFrameChg>
        <pc:graphicFrameChg chg="add mod">
          <ac:chgData name="Lucia Pedicini" userId="5525d782-bff0-43e0-ac01-65707fcdbdc6" providerId="ADAL" clId="{4EF33EA4-6D56-41E9-98F5-3CF96A6C152C}" dt="2021-10-08T12:32:39.106" v="374" actId="1035"/>
          <ac:graphicFrameMkLst>
            <pc:docMk/>
            <pc:sldMk cId="3217791992" sldId="257"/>
            <ac:graphicFrameMk id="48" creationId="{072B5A5B-A3E2-42E6-98B1-62405533E6FE}"/>
          </ac:graphicFrameMkLst>
        </pc:graphicFrameChg>
        <pc:graphicFrameChg chg="add mod">
          <ac:chgData name="Lucia Pedicini" userId="5525d782-bff0-43e0-ac01-65707fcdbdc6" providerId="ADAL" clId="{4EF33EA4-6D56-41E9-98F5-3CF96A6C152C}" dt="2021-10-08T12:33:53.895" v="390" actId="1076"/>
          <ac:graphicFrameMkLst>
            <pc:docMk/>
            <pc:sldMk cId="3217791992" sldId="257"/>
            <ac:graphicFrameMk id="55" creationId="{9EAA986C-1185-4652-94B9-D10FCC8F81F7}"/>
          </ac:graphicFrameMkLst>
        </pc:graphicFrameChg>
        <pc:graphicFrameChg chg="add mod">
          <ac:chgData name="Lucia Pedicini" userId="5525d782-bff0-43e0-ac01-65707fcdbdc6" providerId="ADAL" clId="{4EF33EA4-6D56-41E9-98F5-3CF96A6C152C}" dt="2021-10-08T12:33:03.438" v="383" actId="1036"/>
          <ac:graphicFrameMkLst>
            <pc:docMk/>
            <pc:sldMk cId="3217791992" sldId="257"/>
            <ac:graphicFrameMk id="56" creationId="{6D49D16A-6710-4C39-BD52-5A99D2645B43}"/>
          </ac:graphicFrameMkLst>
        </pc:graphicFrameChg>
        <pc:picChg chg="mod">
          <ac:chgData name="Lucia Pedicini" userId="5525d782-bff0-43e0-ac01-65707fcdbdc6" providerId="ADAL" clId="{4EF33EA4-6D56-41E9-98F5-3CF96A6C152C}" dt="2021-10-08T12:32:39.106" v="374" actId="1035"/>
          <ac:picMkLst>
            <pc:docMk/>
            <pc:sldMk cId="3217791992" sldId="257"/>
            <ac:picMk id="5" creationId="{8FA507FF-32A5-4367-A514-CE5E54FE0968}"/>
          </ac:picMkLst>
        </pc:picChg>
        <pc:picChg chg="mod">
          <ac:chgData name="Lucia Pedicini" userId="5525d782-bff0-43e0-ac01-65707fcdbdc6" providerId="ADAL" clId="{4EF33EA4-6D56-41E9-98F5-3CF96A6C152C}" dt="2021-10-08T12:32:39.106" v="374" actId="1035"/>
          <ac:picMkLst>
            <pc:docMk/>
            <pc:sldMk cId="3217791992" sldId="257"/>
            <ac:picMk id="14" creationId="{EF6DD556-270D-4450-A5A3-17D87AA47381}"/>
          </ac:picMkLst>
        </pc:picChg>
        <pc:picChg chg="mod modCrop">
          <ac:chgData name="Lucia Pedicini" userId="5525d782-bff0-43e0-ac01-65707fcdbdc6" providerId="ADAL" clId="{4EF33EA4-6D56-41E9-98F5-3CF96A6C152C}" dt="2021-10-08T12:32:39.106" v="374" actId="1035"/>
          <ac:picMkLst>
            <pc:docMk/>
            <pc:sldMk cId="3217791992" sldId="257"/>
            <ac:picMk id="33" creationId="{5CEEE964-E118-4EE6-A078-00D652DD68EC}"/>
          </ac:picMkLst>
        </pc:picChg>
        <pc:picChg chg="add mod">
          <ac:chgData name="Lucia Pedicini" userId="5525d782-bff0-43e0-ac01-65707fcdbdc6" providerId="ADAL" clId="{4EF33EA4-6D56-41E9-98F5-3CF96A6C152C}" dt="2021-10-08T12:32:39.106" v="374" actId="1035"/>
          <ac:picMkLst>
            <pc:docMk/>
            <pc:sldMk cId="3217791992" sldId="257"/>
            <ac:picMk id="45" creationId="{F87B14BE-DAB8-4768-8DDE-8F11F63E0464}"/>
          </ac:picMkLst>
        </pc:picChg>
        <pc:picChg chg="add mod">
          <ac:chgData name="Lucia Pedicini" userId="5525d782-bff0-43e0-ac01-65707fcdbdc6" providerId="ADAL" clId="{4EF33EA4-6D56-41E9-98F5-3CF96A6C152C}" dt="2021-10-08T12:32:39.106" v="374" actId="1035"/>
          <ac:picMkLst>
            <pc:docMk/>
            <pc:sldMk cId="3217791992" sldId="257"/>
            <ac:picMk id="46" creationId="{7A8380B0-FAC7-404C-9DE4-F0B56FD7DF61}"/>
          </ac:picMkLst>
        </pc:picChg>
        <pc:picChg chg="add mod">
          <ac:chgData name="Lucia Pedicini" userId="5525d782-bff0-43e0-ac01-65707fcdbdc6" providerId="ADAL" clId="{4EF33EA4-6D56-41E9-98F5-3CF96A6C152C}" dt="2021-10-08T12:32:39.106" v="374" actId="1035"/>
          <ac:picMkLst>
            <pc:docMk/>
            <pc:sldMk cId="3217791992" sldId="257"/>
            <ac:picMk id="47" creationId="{72EE54A8-2D2C-49CC-8973-3F6F09714482}"/>
          </ac:picMkLst>
        </pc:picChg>
        <pc:picChg chg="mod">
          <ac:chgData name="Lucia Pedicini" userId="5525d782-bff0-43e0-ac01-65707fcdbdc6" providerId="ADAL" clId="{4EF33EA4-6D56-41E9-98F5-3CF96A6C152C}" dt="2021-10-08T12:32:39.106" v="374" actId="1035"/>
          <ac:picMkLst>
            <pc:docMk/>
            <pc:sldMk cId="3217791992" sldId="257"/>
            <ac:picMk id="50" creationId="{0EDF276C-97E5-4D77-9D3A-3C7D1C4B58D5}"/>
          </ac:picMkLst>
        </pc:picChg>
        <pc:cxnChg chg="mod">
          <ac:chgData name="Lucia Pedicini" userId="5525d782-bff0-43e0-ac01-65707fcdbdc6" providerId="ADAL" clId="{4EF33EA4-6D56-41E9-98F5-3CF96A6C152C}" dt="2021-10-08T12:21:18.961" v="218" actId="14100"/>
          <ac:cxnSpMkLst>
            <pc:docMk/>
            <pc:sldMk cId="3217791992" sldId="257"/>
            <ac:cxnSpMk id="43" creationId="{8635B1B8-351A-4F17-80DD-6E0960DCC6CF}"/>
          </ac:cxnSpMkLst>
        </pc:cxnChg>
      </pc:sldChg>
      <pc:sldChg chg="addSp delSp modSp add mod modNotesTx">
        <pc:chgData name="Lucia Pedicini" userId="5525d782-bff0-43e0-ac01-65707fcdbdc6" providerId="ADAL" clId="{4EF33EA4-6D56-41E9-98F5-3CF96A6C152C}" dt="2021-10-08T12:52:43.644" v="740"/>
        <pc:sldMkLst>
          <pc:docMk/>
          <pc:sldMk cId="4099387880" sldId="258"/>
        </pc:sldMkLst>
        <pc:spChg chg="mod">
          <ac:chgData name="Lucia Pedicini" userId="5525d782-bff0-43e0-ac01-65707fcdbdc6" providerId="ADAL" clId="{4EF33EA4-6D56-41E9-98F5-3CF96A6C152C}" dt="2021-10-08T12:41:44.936" v="516" actId="1038"/>
          <ac:spMkLst>
            <pc:docMk/>
            <pc:sldMk cId="4099387880" sldId="258"/>
            <ac:spMk id="2" creationId="{5607D777-C52C-4459-880C-A33B232A04FA}"/>
          </ac:spMkLst>
        </pc:spChg>
        <pc:spChg chg="mod">
          <ac:chgData name="Lucia Pedicini" userId="5525d782-bff0-43e0-ac01-65707fcdbdc6" providerId="ADAL" clId="{4EF33EA4-6D56-41E9-98F5-3CF96A6C152C}" dt="2021-10-08T12:41:31.856" v="511" actId="14100"/>
          <ac:spMkLst>
            <pc:docMk/>
            <pc:sldMk cId="4099387880" sldId="258"/>
            <ac:spMk id="3" creationId="{6533F1A3-BF20-4035-9A44-25541571CD4A}"/>
          </ac:spMkLst>
        </pc:spChg>
        <pc:spChg chg="add mod">
          <ac:chgData name="Lucia Pedicini" userId="5525d782-bff0-43e0-ac01-65707fcdbdc6" providerId="ADAL" clId="{4EF33EA4-6D56-41E9-98F5-3CF96A6C152C}" dt="2021-10-08T12:45:35.391" v="610" actId="1035"/>
          <ac:spMkLst>
            <pc:docMk/>
            <pc:sldMk cId="4099387880" sldId="258"/>
            <ac:spMk id="9" creationId="{66E88461-F636-4AC8-81B5-44524996778C}"/>
          </ac:spMkLst>
        </pc:spChg>
        <pc:spChg chg="del">
          <ac:chgData name="Lucia Pedicini" userId="5525d782-bff0-43e0-ac01-65707fcdbdc6" providerId="ADAL" clId="{4EF33EA4-6D56-41E9-98F5-3CF96A6C152C}" dt="2021-10-08T12:41:19.438" v="508" actId="478"/>
          <ac:spMkLst>
            <pc:docMk/>
            <pc:sldMk cId="4099387880" sldId="258"/>
            <ac:spMk id="38" creationId="{A3F2E2F3-DA73-4813-8E3F-B780B117BF52}"/>
          </ac:spMkLst>
        </pc:spChg>
        <pc:spChg chg="mod">
          <ac:chgData name="Lucia Pedicini" userId="5525d782-bff0-43e0-ac01-65707fcdbdc6" providerId="ADAL" clId="{4EF33EA4-6D56-41E9-98F5-3CF96A6C152C}" dt="2021-10-08T12:48:00.862" v="676" actId="1076"/>
          <ac:spMkLst>
            <pc:docMk/>
            <pc:sldMk cId="4099387880" sldId="258"/>
            <ac:spMk id="39" creationId="{8BFE5FF1-6B6F-4993-B244-03859D1970C0}"/>
          </ac:spMkLst>
        </pc:spChg>
        <pc:spChg chg="del mod">
          <ac:chgData name="Lucia Pedicini" userId="5525d782-bff0-43e0-ac01-65707fcdbdc6" providerId="ADAL" clId="{4EF33EA4-6D56-41E9-98F5-3CF96A6C152C}" dt="2021-10-08T12:42:39.305" v="520" actId="478"/>
          <ac:spMkLst>
            <pc:docMk/>
            <pc:sldMk cId="4099387880" sldId="258"/>
            <ac:spMk id="44" creationId="{42D3317F-DCD0-4A8A-B0CA-A8DACB416CFD}"/>
          </ac:spMkLst>
        </pc:spChg>
        <pc:spChg chg="mod">
          <ac:chgData name="Lucia Pedicini" userId="5525d782-bff0-43e0-ac01-65707fcdbdc6" providerId="ADAL" clId="{4EF33EA4-6D56-41E9-98F5-3CF96A6C152C}" dt="2021-10-08T12:46:53.904" v="664" actId="20577"/>
          <ac:spMkLst>
            <pc:docMk/>
            <pc:sldMk cId="4099387880" sldId="258"/>
            <ac:spMk id="49" creationId="{C903109D-1477-4C29-9E13-8C4CEA00C7A4}"/>
          </ac:spMkLst>
        </pc:spChg>
        <pc:spChg chg="mod">
          <ac:chgData name="Lucia Pedicini" userId="5525d782-bff0-43e0-ac01-65707fcdbdc6" providerId="ADAL" clId="{4EF33EA4-6D56-41E9-98F5-3CF96A6C152C}" dt="2021-10-08T12:46:59.002" v="666" actId="20577"/>
          <ac:spMkLst>
            <pc:docMk/>
            <pc:sldMk cId="4099387880" sldId="258"/>
            <ac:spMk id="51" creationId="{25292889-46CE-46DF-A2D7-02209177AEE7}"/>
          </ac:spMkLst>
        </pc:spChg>
        <pc:spChg chg="mod">
          <ac:chgData name="Lucia Pedicini" userId="5525d782-bff0-43e0-ac01-65707fcdbdc6" providerId="ADAL" clId="{4EF33EA4-6D56-41E9-98F5-3CF96A6C152C}" dt="2021-10-08T12:47:12.822" v="669" actId="20577"/>
          <ac:spMkLst>
            <pc:docMk/>
            <pc:sldMk cId="4099387880" sldId="258"/>
            <ac:spMk id="52" creationId="{9B2197C4-861B-4C7A-83CF-31B9E48A4B06}"/>
          </ac:spMkLst>
        </pc:spChg>
        <pc:spChg chg="mod">
          <ac:chgData name="Lucia Pedicini" userId="5525d782-bff0-43e0-ac01-65707fcdbdc6" providerId="ADAL" clId="{4EF33EA4-6D56-41E9-98F5-3CF96A6C152C}" dt="2021-10-08T12:47:32.879" v="671" actId="20577"/>
          <ac:spMkLst>
            <pc:docMk/>
            <pc:sldMk cId="4099387880" sldId="258"/>
            <ac:spMk id="53" creationId="{5386E2DC-DBBE-4E42-8A35-DE74447CAB0E}"/>
          </ac:spMkLst>
        </pc:spChg>
        <pc:spChg chg="mod">
          <ac:chgData name="Lucia Pedicini" userId="5525d782-bff0-43e0-ac01-65707fcdbdc6" providerId="ADAL" clId="{4EF33EA4-6D56-41E9-98F5-3CF96A6C152C}" dt="2021-10-08T12:47:37.113" v="673" actId="20577"/>
          <ac:spMkLst>
            <pc:docMk/>
            <pc:sldMk cId="4099387880" sldId="258"/>
            <ac:spMk id="54" creationId="{5E2C67C9-C8D2-451A-8A4F-624650C93724}"/>
          </ac:spMkLst>
        </pc:spChg>
        <pc:spChg chg="mod">
          <ac:chgData name="Lucia Pedicini" userId="5525d782-bff0-43e0-ac01-65707fcdbdc6" providerId="ADAL" clId="{4EF33EA4-6D56-41E9-98F5-3CF96A6C152C}" dt="2021-10-08T12:47:40.367" v="675" actId="20577"/>
          <ac:spMkLst>
            <pc:docMk/>
            <pc:sldMk cId="4099387880" sldId="258"/>
            <ac:spMk id="57" creationId="{9C2766FA-DE6C-4BA0-B5C4-E655555064D0}"/>
          </ac:spMkLst>
        </pc:spChg>
        <pc:spChg chg="add mod">
          <ac:chgData name="Lucia Pedicini" userId="5525d782-bff0-43e0-ac01-65707fcdbdc6" providerId="ADAL" clId="{4EF33EA4-6D56-41E9-98F5-3CF96A6C152C}" dt="2021-10-08T12:46:42.960" v="660" actId="1076"/>
          <ac:spMkLst>
            <pc:docMk/>
            <pc:sldMk cId="4099387880" sldId="258"/>
            <ac:spMk id="58" creationId="{1CB2D6B8-6657-4502-84E7-2C90812FEC6A}"/>
          </ac:spMkLst>
        </pc:spChg>
        <pc:spChg chg="add del mod">
          <ac:chgData name="Lucia Pedicini" userId="5525d782-bff0-43e0-ac01-65707fcdbdc6" providerId="ADAL" clId="{4EF33EA4-6D56-41E9-98F5-3CF96A6C152C}" dt="2021-10-08T12:43:47.318" v="530" actId="478"/>
          <ac:spMkLst>
            <pc:docMk/>
            <pc:sldMk cId="4099387880" sldId="258"/>
            <ac:spMk id="59" creationId="{4C8B2193-98CA-4730-B593-903CD57D7DC3}"/>
          </ac:spMkLst>
        </pc:spChg>
        <pc:spChg chg="add mod">
          <ac:chgData name="Lucia Pedicini" userId="5525d782-bff0-43e0-ac01-65707fcdbdc6" providerId="ADAL" clId="{4EF33EA4-6D56-41E9-98F5-3CF96A6C152C}" dt="2021-10-08T12:44:04.885" v="585" actId="1038"/>
          <ac:spMkLst>
            <pc:docMk/>
            <pc:sldMk cId="4099387880" sldId="258"/>
            <ac:spMk id="60" creationId="{C7280231-51ED-4B88-8E57-FB4FF1A96AD2}"/>
          </ac:spMkLst>
        </pc:spChg>
        <pc:spChg chg="add mod">
          <ac:chgData name="Lucia Pedicini" userId="5525d782-bff0-43e0-ac01-65707fcdbdc6" providerId="ADAL" clId="{4EF33EA4-6D56-41E9-98F5-3CF96A6C152C}" dt="2021-10-08T12:46:08.908" v="612" actId="1076"/>
          <ac:spMkLst>
            <pc:docMk/>
            <pc:sldMk cId="4099387880" sldId="258"/>
            <ac:spMk id="61" creationId="{988C621C-D2D2-4917-B44C-9A6AFD28C2D5}"/>
          </ac:spMkLst>
        </pc:spChg>
        <pc:cxnChg chg="add mod">
          <ac:chgData name="Lucia Pedicini" userId="5525d782-bff0-43e0-ac01-65707fcdbdc6" providerId="ADAL" clId="{4EF33EA4-6D56-41E9-98F5-3CF96A6C152C}" dt="2021-10-08T12:46:11.969" v="613" actId="1076"/>
          <ac:cxnSpMkLst>
            <pc:docMk/>
            <pc:sldMk cId="4099387880" sldId="258"/>
            <ac:cxnSpMk id="8" creationId="{A20854D0-6409-47F0-BBEC-79DC6A76A354}"/>
          </ac:cxnSpMkLst>
        </pc:cxnChg>
        <pc:cxnChg chg="add mod">
          <ac:chgData name="Lucia Pedicini" userId="5525d782-bff0-43e0-ac01-65707fcdbdc6" providerId="ADAL" clId="{4EF33EA4-6D56-41E9-98F5-3CF96A6C152C}" dt="2021-10-08T12:46:17.864" v="657" actId="1035"/>
          <ac:cxnSpMkLst>
            <pc:docMk/>
            <pc:sldMk cId="4099387880" sldId="258"/>
            <ac:cxnSpMk id="62" creationId="{CA3442D4-06AD-416F-BD7C-2BD2CE05BCEF}"/>
          </ac:cxnSpMkLst>
        </pc:cxnChg>
      </pc:sldChg>
    </pc:docChg>
  </pc:docChgLst>
  <pc:docChgLst>
    <pc:chgData name="Lucia Pedicini" userId="5525d782-bff0-43e0-ac01-65707fcdbdc6" providerId="ADAL" clId="{FDB98570-8C3B-4D46-9CDF-04B3B4C8977F}"/>
    <pc:docChg chg="custSel modSld">
      <pc:chgData name="Lucia Pedicini" userId="5525d782-bff0-43e0-ac01-65707fcdbdc6" providerId="ADAL" clId="{FDB98570-8C3B-4D46-9CDF-04B3B4C8977F}" dt="2021-11-26T10:26:59.059" v="263" actId="1035"/>
      <pc:docMkLst>
        <pc:docMk/>
      </pc:docMkLst>
      <pc:sldChg chg="addSp delSp modSp mod">
        <pc:chgData name="Lucia Pedicini" userId="5525d782-bff0-43e0-ac01-65707fcdbdc6" providerId="ADAL" clId="{FDB98570-8C3B-4D46-9CDF-04B3B4C8977F}" dt="2021-11-26T10:26:59.059" v="263" actId="1035"/>
        <pc:sldMkLst>
          <pc:docMk/>
          <pc:sldMk cId="4099387880" sldId="258"/>
        </pc:sldMkLst>
        <pc:spChg chg="add mod">
          <ac:chgData name="Lucia Pedicini" userId="5525d782-bff0-43e0-ac01-65707fcdbdc6" providerId="ADAL" clId="{FDB98570-8C3B-4D46-9CDF-04B3B4C8977F}" dt="2021-11-23T11:43:52.955" v="241" actId="208"/>
          <ac:spMkLst>
            <pc:docMk/>
            <pc:sldMk cId="4099387880" sldId="258"/>
            <ac:spMk id="4" creationId="{FD5E1DE6-B5C9-4C7C-8F7D-14401285DCF2}"/>
          </ac:spMkLst>
        </pc:spChg>
        <pc:spChg chg="add mod">
          <ac:chgData name="Lucia Pedicini" userId="5525d782-bff0-43e0-ac01-65707fcdbdc6" providerId="ADAL" clId="{FDB98570-8C3B-4D46-9CDF-04B3B4C8977F}" dt="2021-11-23T11:43:15.558" v="233" actId="14100"/>
          <ac:spMkLst>
            <pc:docMk/>
            <pc:sldMk cId="4099387880" sldId="258"/>
            <ac:spMk id="64" creationId="{A63CB3A2-168F-402B-A4B6-0CB134B4C13D}"/>
          </ac:spMkLst>
        </pc:spChg>
        <pc:spChg chg="add mod">
          <ac:chgData name="Lucia Pedicini" userId="5525d782-bff0-43e0-ac01-65707fcdbdc6" providerId="ADAL" clId="{FDB98570-8C3B-4D46-9CDF-04B3B4C8977F}" dt="2021-11-23T11:44:14.962" v="244" actId="1076"/>
          <ac:spMkLst>
            <pc:docMk/>
            <pc:sldMk cId="4099387880" sldId="258"/>
            <ac:spMk id="65" creationId="{EB750B69-8B9F-4E7E-8249-F8708E2D3258}"/>
          </ac:spMkLst>
        </pc:spChg>
        <pc:spChg chg="add mod">
          <ac:chgData name="Lucia Pedicini" userId="5525d782-bff0-43e0-ac01-65707fcdbdc6" providerId="ADAL" clId="{FDB98570-8C3B-4D46-9CDF-04B3B4C8977F}" dt="2021-11-23T11:44:03.012" v="243" actId="1076"/>
          <ac:spMkLst>
            <pc:docMk/>
            <pc:sldMk cId="4099387880" sldId="258"/>
            <ac:spMk id="66" creationId="{7CC960A0-EFC1-4D7F-B841-A614C37E23C7}"/>
          </ac:spMkLst>
        </pc:spChg>
        <pc:graphicFrameChg chg="del">
          <ac:chgData name="Lucia Pedicini" userId="5525d782-bff0-43e0-ac01-65707fcdbdc6" providerId="ADAL" clId="{FDB98570-8C3B-4D46-9CDF-04B3B4C8977F}" dt="2021-11-26T10:26:44.131" v="249" actId="478"/>
          <ac:graphicFrameMkLst>
            <pc:docMk/>
            <pc:sldMk cId="4099387880" sldId="258"/>
            <ac:graphicFrameMk id="7" creationId="{9FF49640-7DC7-4722-9B25-070FEA408A8B}"/>
          </ac:graphicFrameMkLst>
        </pc:graphicFrameChg>
        <pc:graphicFrameChg chg="add mod">
          <ac:chgData name="Lucia Pedicini" userId="5525d782-bff0-43e0-ac01-65707fcdbdc6" providerId="ADAL" clId="{FDB98570-8C3B-4D46-9CDF-04B3B4C8977F}" dt="2021-11-26T10:26:59.059" v="263" actId="1035"/>
          <ac:graphicFrameMkLst>
            <pc:docMk/>
            <pc:sldMk cId="4099387880" sldId="258"/>
            <ac:graphicFrameMk id="10" creationId="{2E00CAB7-5F79-4886-9E3A-B29C5ECDD06F}"/>
          </ac:graphicFrameMkLst>
        </pc:graphicFrameChg>
        <pc:graphicFrameChg chg="add mod">
          <ac:chgData name="Lucia Pedicini" userId="5525d782-bff0-43e0-ac01-65707fcdbdc6" providerId="ADAL" clId="{FDB98570-8C3B-4D46-9CDF-04B3B4C8977F}" dt="2021-11-19T14:54:23.690" v="195" actId="1038"/>
          <ac:graphicFrameMkLst>
            <pc:docMk/>
            <pc:sldMk cId="4099387880" sldId="258"/>
            <ac:graphicFrameMk id="59" creationId="{1FEDF69D-81D7-44D1-A66D-9CBCB35513DB}"/>
          </ac:graphicFrameMkLst>
        </pc:graphicFrameChg>
        <pc:graphicFrameChg chg="add mod">
          <ac:chgData name="Lucia Pedicini" userId="5525d782-bff0-43e0-ac01-65707fcdbdc6" providerId="ADAL" clId="{FDB98570-8C3B-4D46-9CDF-04B3B4C8977F}" dt="2021-11-19T14:55:32.223" v="221" actId="1037"/>
          <ac:graphicFrameMkLst>
            <pc:docMk/>
            <pc:sldMk cId="4099387880" sldId="258"/>
            <ac:graphicFrameMk id="63" creationId="{123972D8-7F92-4413-81C1-C45236CF1E42}"/>
          </ac:graphicFrameMkLst>
        </pc:graphicFrameChg>
        <pc:picChg chg="del mod">
          <ac:chgData name="Lucia Pedicini" userId="5525d782-bff0-43e0-ac01-65707fcdbdc6" providerId="ADAL" clId="{FDB98570-8C3B-4D46-9CDF-04B3B4C8977F}" dt="2021-11-19T14:53:17.879" v="2" actId="478"/>
          <ac:picMkLst>
            <pc:docMk/>
            <pc:sldMk cId="4099387880" sldId="258"/>
            <ac:picMk id="45" creationId="{F87B14BE-DAB8-4768-8DDE-8F11F63E0464}"/>
          </ac:picMkLst>
        </pc:picChg>
        <pc:picChg chg="del">
          <ac:chgData name="Lucia Pedicini" userId="5525d782-bff0-43e0-ac01-65707fcdbdc6" providerId="ADAL" clId="{FDB98570-8C3B-4D46-9CDF-04B3B4C8977F}" dt="2021-11-19T14:53:15.720" v="1" actId="478"/>
          <ac:picMkLst>
            <pc:docMk/>
            <pc:sldMk cId="4099387880" sldId="258"/>
            <ac:picMk id="46" creationId="{7A8380B0-FAC7-404C-9DE4-F0B56FD7DF61}"/>
          </ac:picMkLst>
        </pc:pic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5AEBD2-0855-471B-8AB9-5D32A5B640C7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94BCEC-75C1-4841-9833-19D01FD18D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779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Option: remove some time points to make easier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94BCEC-75C1-4841-9833-19D01FD18D4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1975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2512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7964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4305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6492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5169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266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8842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143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2204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884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9473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5C9C0-5472-4126-A87D-117E4463E5A4}" type="datetimeFigureOut">
              <a:rPr lang="en-GB" smtClean="0"/>
              <a:t>01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1C0DD9-8180-4946-AE49-E93F13F19D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1116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16.png"/><Relationship Id="rId18" Type="http://schemas.openxmlformats.org/officeDocument/2006/relationships/oleObject" Target="../embeddings/oleObject4.bin"/><Relationship Id="rId26" Type="http://schemas.openxmlformats.org/officeDocument/2006/relationships/oleObject" Target="../embeddings/oleObject8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5.wmf"/><Relationship Id="rId7" Type="http://schemas.openxmlformats.org/officeDocument/2006/relationships/image" Target="../media/image12.emf"/><Relationship Id="rId12" Type="http://schemas.openxmlformats.org/officeDocument/2006/relationships/image" Target="../media/image15.png"/><Relationship Id="rId17" Type="http://schemas.openxmlformats.org/officeDocument/2006/relationships/image" Target="../media/image3.wmf"/><Relationship Id="rId25" Type="http://schemas.openxmlformats.org/officeDocument/2006/relationships/image" Target="../media/image7.w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3.bin"/><Relationship Id="rId20" Type="http://schemas.openxmlformats.org/officeDocument/2006/relationships/oleObject" Target="../embeddings/oleObject5.bin"/><Relationship Id="rId29" Type="http://schemas.openxmlformats.org/officeDocument/2006/relationships/image" Target="../media/image9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1.tif"/><Relationship Id="rId11" Type="http://schemas.openxmlformats.org/officeDocument/2006/relationships/image" Target="../media/image14.png"/><Relationship Id="rId24" Type="http://schemas.openxmlformats.org/officeDocument/2006/relationships/oleObject" Target="../embeddings/oleObject7.bin"/><Relationship Id="rId5" Type="http://schemas.openxmlformats.org/officeDocument/2006/relationships/image" Target="../media/image1.wmf"/><Relationship Id="rId15" Type="http://schemas.openxmlformats.org/officeDocument/2006/relationships/image" Target="../media/image18.png"/><Relationship Id="rId23" Type="http://schemas.openxmlformats.org/officeDocument/2006/relationships/image" Target="../media/image6.wmf"/><Relationship Id="rId28" Type="http://schemas.openxmlformats.org/officeDocument/2006/relationships/oleObject" Target="../embeddings/oleObject9.bin"/><Relationship Id="rId10" Type="http://schemas.openxmlformats.org/officeDocument/2006/relationships/image" Target="../media/image13.png"/><Relationship Id="rId19" Type="http://schemas.openxmlformats.org/officeDocument/2006/relationships/image" Target="../media/image4.wmf"/><Relationship Id="rId31" Type="http://schemas.openxmlformats.org/officeDocument/2006/relationships/image" Target="../media/image10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2.wmf"/><Relationship Id="rId14" Type="http://schemas.openxmlformats.org/officeDocument/2006/relationships/image" Target="../media/image17.png"/><Relationship Id="rId22" Type="http://schemas.openxmlformats.org/officeDocument/2006/relationships/oleObject" Target="../embeddings/oleObject6.bin"/><Relationship Id="rId27" Type="http://schemas.openxmlformats.org/officeDocument/2006/relationships/image" Target="../media/image8.wmf"/><Relationship Id="rId30" Type="http://schemas.openxmlformats.org/officeDocument/2006/relationships/oleObject" Target="../embeddings/oleObject10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TextBox 107"/>
          <p:cNvSpPr txBox="1"/>
          <p:nvPr/>
        </p:nvSpPr>
        <p:spPr>
          <a:xfrm rot="16200000">
            <a:off x="2154226" y="4284578"/>
            <a:ext cx="973343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amine release (%)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8AD979F-C3CF-4ECD-AB90-D54C8FB261EE}"/>
              </a:ext>
            </a:extLst>
          </p:cNvPr>
          <p:cNvSpPr txBox="1"/>
          <p:nvPr/>
        </p:nvSpPr>
        <p:spPr>
          <a:xfrm>
            <a:off x="145478" y="195364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06F5CC8-5A56-4EBD-B73A-5501BC02AC58}"/>
              </a:ext>
            </a:extLst>
          </p:cNvPr>
          <p:cNvSpPr txBox="1"/>
          <p:nvPr/>
        </p:nvSpPr>
        <p:spPr>
          <a:xfrm>
            <a:off x="145478" y="654721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D788286-F91D-4CE6-B828-DA226C33BD60}"/>
              </a:ext>
            </a:extLst>
          </p:cNvPr>
          <p:cNvSpPr txBox="1"/>
          <p:nvPr/>
        </p:nvSpPr>
        <p:spPr>
          <a:xfrm>
            <a:off x="145478" y="2232816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c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8622D86-A4DA-45F9-9F6E-6D55E8BB0D6E}"/>
              </a:ext>
            </a:extLst>
          </p:cNvPr>
          <p:cNvSpPr txBox="1"/>
          <p:nvPr/>
        </p:nvSpPr>
        <p:spPr>
          <a:xfrm>
            <a:off x="145478" y="366257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d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2E00CAB7-5F79-4886-9E3A-B29C5ECDD0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7746887"/>
              </p:ext>
            </p:extLst>
          </p:nvPr>
        </p:nvGraphicFramePr>
        <p:xfrm>
          <a:off x="186434" y="3775827"/>
          <a:ext cx="1972770" cy="15095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0" name="Graph" r:id="rId4" imgW="3920760" imgH="3000960" progId="Origin95.Graph">
                  <p:embed/>
                </p:oleObj>
              </mc:Choice>
              <mc:Fallback>
                <p:oleObj name="Graph" r:id="rId4" imgW="3920760" imgH="3000960" progId="Origin95.Graph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2E00CAB7-5F79-4886-9E3A-B29C5ECDD06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6434" y="3775827"/>
                        <a:ext cx="1972770" cy="15095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2" name="Group 111"/>
          <p:cNvGrpSpPr/>
          <p:nvPr/>
        </p:nvGrpSpPr>
        <p:grpSpPr>
          <a:xfrm>
            <a:off x="171475" y="252443"/>
            <a:ext cx="2016073" cy="452576"/>
            <a:chOff x="171475" y="3578744"/>
            <a:chExt cx="2016073" cy="452576"/>
          </a:xfrm>
        </p:grpSpPr>
        <p:pic>
          <p:nvPicPr>
            <p:cNvPr id="14" name="Picture 13" descr="A picture containing text, electronics, black, screen&#10;&#10;Description automatically generated">
              <a:extLst>
                <a:ext uri="{FF2B5EF4-FFF2-40B4-BE49-F238E27FC236}">
                  <a16:creationId xmlns:a16="http://schemas.microsoft.com/office/drawing/2014/main" id="{EF6DD556-270D-4450-A5A3-17D87AA473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723" t="716" b="79354"/>
            <a:stretch/>
          </p:blipFill>
          <p:spPr>
            <a:xfrm>
              <a:off x="171475" y="3765341"/>
              <a:ext cx="1964876" cy="265979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F525EA3-4DE6-4843-AF7C-7C2108840F24}"/>
                </a:ext>
              </a:extLst>
            </p:cNvPr>
            <p:cNvSpPr txBox="1"/>
            <p:nvPr/>
          </p:nvSpPr>
          <p:spPr>
            <a:xfrm>
              <a:off x="803016" y="3578744"/>
              <a:ext cx="5357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 smtClean="0"/>
                <a:t>Rab46</a:t>
              </a:r>
              <a:endParaRPr lang="en-GB" sz="1050" b="1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1881021" y="3746755"/>
              <a:ext cx="306527" cy="141212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600" b="1" dirty="0" smtClean="0"/>
                <a:t>732</a:t>
              </a:r>
              <a:endParaRPr lang="en-GB" sz="600" b="1" dirty="0"/>
            </a:p>
          </p:txBody>
        </p:sp>
        <p:sp>
          <p:nvSpPr>
            <p:cNvPr id="57" name="Rectangle 56"/>
            <p:cNvSpPr/>
            <p:nvPr/>
          </p:nvSpPr>
          <p:spPr>
            <a:xfrm>
              <a:off x="180701" y="3746755"/>
              <a:ext cx="165947" cy="146966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600" b="1" dirty="0" smtClean="0"/>
                <a:t>1</a:t>
              </a:r>
              <a:endParaRPr lang="en-GB" sz="600" b="1" dirty="0"/>
            </a:p>
          </p:txBody>
        </p:sp>
      </p:grpSp>
      <p:grpSp>
        <p:nvGrpSpPr>
          <p:cNvPr id="113" name="Group 112"/>
          <p:cNvGrpSpPr/>
          <p:nvPr/>
        </p:nvGrpSpPr>
        <p:grpSpPr>
          <a:xfrm>
            <a:off x="320152" y="627623"/>
            <a:ext cx="1342918" cy="1590888"/>
            <a:chOff x="320152" y="508354"/>
            <a:chExt cx="1342918" cy="159088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FA507FF-32A5-4367-A514-CE5E54FE09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884" t="1" r="27756" b="557"/>
            <a:stretch/>
          </p:blipFill>
          <p:spPr>
            <a:xfrm>
              <a:off x="320152" y="508354"/>
              <a:ext cx="1342918" cy="1590888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643438" y="579279"/>
              <a:ext cx="100785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man skin mast cells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4" name="Group 113"/>
          <p:cNvGrpSpPr/>
          <p:nvPr/>
        </p:nvGrpSpPr>
        <p:grpSpPr>
          <a:xfrm>
            <a:off x="319457" y="2313607"/>
            <a:ext cx="1756161" cy="1345601"/>
            <a:chOff x="319457" y="2083904"/>
            <a:chExt cx="1756161" cy="1345601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43926E4D-3A83-4D3A-B060-208B59C70CB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31494751"/>
                </p:ext>
              </p:extLst>
            </p:nvPr>
          </p:nvGraphicFramePr>
          <p:xfrm>
            <a:off x="319457" y="2083904"/>
            <a:ext cx="1756161" cy="13456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41" name="Graph" r:id="rId8" imgW="3920760" imgH="3000960" progId="Origin95.Graph">
                    <p:embed/>
                  </p:oleObj>
                </mc:Choice>
                <mc:Fallback>
                  <p:oleObj name="Graph" r:id="rId8" imgW="3920760" imgH="3000960" progId="Origin95.Graph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43926E4D-3A83-4D3A-B060-208B59C70CB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19457" y="2083904"/>
                          <a:ext cx="1756161" cy="13456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9" name="TextBox 78"/>
            <p:cNvSpPr txBox="1"/>
            <p:nvPr/>
          </p:nvSpPr>
          <p:spPr>
            <a:xfrm>
              <a:off x="638417" y="2089721"/>
              <a:ext cx="903898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rine mast cells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2248342" y="439157"/>
            <a:ext cx="4606784" cy="8244945"/>
            <a:chOff x="2327854" y="130800"/>
            <a:chExt cx="4606784" cy="8244945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AE621AE-4996-445F-9308-D7F5F18CED06}"/>
                </a:ext>
              </a:extLst>
            </p:cNvPr>
            <p:cNvSpPr txBox="1"/>
            <p:nvPr/>
          </p:nvSpPr>
          <p:spPr>
            <a:xfrm>
              <a:off x="2584243" y="510614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g</a:t>
              </a:r>
              <a:endParaRPr lang="en-GB" sz="1200" b="1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BFE5FF1-6B6F-4993-B244-03859D1970C0}"/>
                </a:ext>
              </a:extLst>
            </p:cNvPr>
            <p:cNvSpPr txBox="1"/>
            <p:nvPr/>
          </p:nvSpPr>
          <p:spPr>
            <a:xfrm>
              <a:off x="2587449" y="3355450"/>
              <a:ext cx="223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err="1" smtClean="0"/>
                <a:t>i</a:t>
              </a:r>
              <a:endParaRPr lang="en-GB" sz="1200" b="1" dirty="0"/>
            </a:p>
          </p:txBody>
        </p: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8635B1B8-351A-4F17-80DD-6E0960DCC6CF}"/>
                </a:ext>
              </a:extLst>
            </p:cNvPr>
            <p:cNvCxnSpPr/>
            <p:nvPr/>
          </p:nvCxnSpPr>
          <p:spPr>
            <a:xfrm>
              <a:off x="3819180" y="7512200"/>
              <a:ext cx="13305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903109D-1477-4C29-9E13-8C4CEA00C7A4}"/>
                </a:ext>
              </a:extLst>
            </p:cNvPr>
            <p:cNvSpPr txBox="1"/>
            <p:nvPr/>
          </p:nvSpPr>
          <p:spPr>
            <a:xfrm>
              <a:off x="2577831" y="5013199"/>
              <a:ext cx="2247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j</a:t>
              </a:r>
              <a:endParaRPr lang="en-GB" sz="1200" b="1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5292889-46CE-46DF-A2D7-02209177AEE7}"/>
                </a:ext>
              </a:extLst>
            </p:cNvPr>
            <p:cNvSpPr txBox="1"/>
            <p:nvPr/>
          </p:nvSpPr>
          <p:spPr>
            <a:xfrm>
              <a:off x="2622715" y="6535805"/>
              <a:ext cx="2584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k</a:t>
              </a:r>
              <a:endParaRPr lang="en-GB" sz="1200" b="1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B2197C4-861B-4C7A-83CF-31B9E48A4B06}"/>
                </a:ext>
              </a:extLst>
            </p:cNvPr>
            <p:cNvSpPr txBox="1"/>
            <p:nvPr/>
          </p:nvSpPr>
          <p:spPr>
            <a:xfrm>
              <a:off x="4824950" y="510614"/>
              <a:ext cx="2247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l</a:t>
              </a:r>
              <a:endParaRPr lang="en-GB" sz="1200" b="1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5E2C67C9-C8D2-451A-8A4F-624650C93724}"/>
                </a:ext>
              </a:extLst>
            </p:cNvPr>
            <p:cNvSpPr txBox="1"/>
            <p:nvPr/>
          </p:nvSpPr>
          <p:spPr>
            <a:xfrm>
              <a:off x="4826554" y="3355450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n</a:t>
              </a:r>
              <a:endParaRPr lang="en-GB" sz="1200" b="1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607D777-C52C-4459-880C-A33B232A04FA}"/>
                </a:ext>
              </a:extLst>
            </p:cNvPr>
            <p:cNvSpPr txBox="1"/>
            <p:nvPr/>
          </p:nvSpPr>
          <p:spPr>
            <a:xfrm rot="16200000">
              <a:off x="1065227" y="3221278"/>
              <a:ext cx="2815347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err="1"/>
                <a:t>IgE</a:t>
              </a:r>
              <a:r>
                <a:rPr lang="en-GB" sz="1100" dirty="0"/>
                <a:t> activation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CB2D6B8-6657-4502-84E7-2C90812FEC6A}"/>
                </a:ext>
              </a:extLst>
            </p:cNvPr>
            <p:cNvSpPr txBox="1"/>
            <p:nvPr/>
          </p:nvSpPr>
          <p:spPr>
            <a:xfrm rot="16200000">
              <a:off x="1125949" y="6371485"/>
              <a:ext cx="2693903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/>
                <a:t>Non-</a:t>
              </a:r>
              <a:r>
                <a:rPr lang="en-GB" sz="1100" dirty="0" err="1"/>
                <a:t>IgE</a:t>
              </a:r>
              <a:r>
                <a:rPr lang="en-GB" sz="1100" dirty="0"/>
                <a:t> activation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6E88461-F636-4AC8-81B5-44524996778C}"/>
                </a:ext>
              </a:extLst>
            </p:cNvPr>
            <p:cNvSpPr txBox="1"/>
            <p:nvPr/>
          </p:nvSpPr>
          <p:spPr>
            <a:xfrm>
              <a:off x="3321189" y="1609498"/>
              <a:ext cx="52378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err="1"/>
                <a:t>Fc</a:t>
              </a:r>
              <a:r>
                <a:rPr lang="en-GB" sz="1100" b="1" dirty="0" err="1">
                  <a:latin typeface="Symbol" panose="05050102010706020507" pitchFamily="18" charset="2"/>
                </a:rPr>
                <a:t>e</a:t>
              </a:r>
              <a:r>
                <a:rPr lang="en-GB" sz="1100" b="1" dirty="0" err="1"/>
                <a:t>RI</a:t>
              </a:r>
              <a:endParaRPr lang="en-GB" sz="1100" b="1" dirty="0"/>
            </a:p>
          </p:txBody>
        </p: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CA3442D4-06AD-416F-BD7C-2BD2CE05BCEF}"/>
                </a:ext>
              </a:extLst>
            </p:cNvPr>
            <p:cNvCxnSpPr/>
            <p:nvPr/>
          </p:nvCxnSpPr>
          <p:spPr>
            <a:xfrm>
              <a:off x="5166059" y="1652655"/>
              <a:ext cx="974838" cy="793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A63CB3A2-168F-402B-A4B6-0CB134B4C13D}"/>
                </a:ext>
              </a:extLst>
            </p:cNvPr>
            <p:cNvSpPr txBox="1"/>
            <p:nvPr/>
          </p:nvSpPr>
          <p:spPr>
            <a:xfrm>
              <a:off x="3123013" y="135085"/>
              <a:ext cx="6787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/>
                <a:t>BMMCs</a:t>
              </a:r>
              <a:endParaRPr lang="en-GB" sz="1100" b="1" dirty="0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EB750B69-8B9F-4E7E-8249-F8708E2D3258}"/>
                </a:ext>
              </a:extLst>
            </p:cNvPr>
            <p:cNvSpPr txBox="1"/>
            <p:nvPr/>
          </p:nvSpPr>
          <p:spPr>
            <a:xfrm>
              <a:off x="5595911" y="135085"/>
              <a:ext cx="6003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/>
                <a:t>PMCs</a:t>
              </a:r>
              <a:endParaRPr lang="en-GB" sz="1100" b="1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E2C67C9-C8D2-451A-8A4F-624650C93724}"/>
                </a:ext>
              </a:extLst>
            </p:cNvPr>
            <p:cNvSpPr txBox="1"/>
            <p:nvPr/>
          </p:nvSpPr>
          <p:spPr>
            <a:xfrm>
              <a:off x="4739992" y="5013199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o</a:t>
              </a:r>
              <a:endParaRPr lang="en-GB" sz="1200" b="1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5E2C67C9-C8D2-451A-8A4F-624650C93724}"/>
                </a:ext>
              </a:extLst>
            </p:cNvPr>
            <p:cNvSpPr txBox="1"/>
            <p:nvPr/>
          </p:nvSpPr>
          <p:spPr>
            <a:xfrm>
              <a:off x="4826554" y="6535805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p</a:t>
              </a:r>
              <a:endParaRPr lang="en-GB" sz="1200" b="1" dirty="0"/>
            </a:p>
          </p:txBody>
        </p:sp>
        <p:cxnSp>
          <p:nvCxnSpPr>
            <p:cNvPr id="15" name="Straight Connector 14"/>
            <p:cNvCxnSpPr/>
            <p:nvPr/>
          </p:nvCxnSpPr>
          <p:spPr>
            <a:xfrm flipH="1">
              <a:off x="4739992" y="437832"/>
              <a:ext cx="38485" cy="7790651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7" name="Group 76"/>
            <p:cNvGrpSpPr/>
            <p:nvPr/>
          </p:nvGrpSpPr>
          <p:grpSpPr>
            <a:xfrm>
              <a:off x="2883516" y="467332"/>
              <a:ext cx="1264020" cy="1265261"/>
              <a:chOff x="2823727" y="467332"/>
              <a:chExt cx="1264020" cy="1265261"/>
            </a:xfrm>
          </p:grpSpPr>
          <p:pic>
            <p:nvPicPr>
              <p:cNvPr id="33" name="Picture 2" descr="Chart, histogram&#10;&#10;Description automatically generated">
                <a:extLst>
                  <a:ext uri="{FF2B5EF4-FFF2-40B4-BE49-F238E27FC236}">
                    <a16:creationId xmlns:a16="http://schemas.microsoft.com/office/drawing/2014/main" id="{5CEEE964-E118-4EE6-A078-00D652DD68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2712" t="1523" r="28199" b="49297"/>
              <a:stretch/>
            </p:blipFill>
            <p:spPr>
              <a:xfrm>
                <a:off x="2837257" y="469616"/>
                <a:ext cx="1183241" cy="1195429"/>
              </a:xfrm>
              <a:prstGeom prst="rect">
                <a:avLst/>
              </a:prstGeom>
            </p:spPr>
          </p:pic>
          <p:sp>
            <p:nvSpPr>
              <p:cNvPr id="46" name="Rectangle 45"/>
              <p:cNvSpPr/>
              <p:nvPr/>
            </p:nvSpPr>
            <p:spPr>
              <a:xfrm>
                <a:off x="2878466" y="467332"/>
                <a:ext cx="1209281" cy="903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2834789" y="1588322"/>
                <a:ext cx="1209281" cy="903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2" name="Rectangle 71"/>
              <p:cNvSpPr/>
              <p:nvPr/>
            </p:nvSpPr>
            <p:spPr>
              <a:xfrm rot="16200000">
                <a:off x="2264242" y="1082797"/>
                <a:ext cx="1209281" cy="903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74" name="Picture 73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3013454" y="1564486"/>
                <a:ext cx="1054699" cy="158510"/>
              </a:xfrm>
              <a:prstGeom prst="rect">
                <a:avLst/>
              </a:prstGeom>
            </p:spPr>
          </p:pic>
        </p:grpSp>
        <p:grpSp>
          <p:nvGrpSpPr>
            <p:cNvPr id="78" name="Group 77"/>
            <p:cNvGrpSpPr/>
            <p:nvPr/>
          </p:nvGrpSpPr>
          <p:grpSpPr>
            <a:xfrm>
              <a:off x="5098179" y="437832"/>
              <a:ext cx="1254436" cy="1433276"/>
              <a:chOff x="4957499" y="437832"/>
              <a:chExt cx="1254436" cy="1433276"/>
            </a:xfrm>
          </p:grpSpPr>
          <p:pic>
            <p:nvPicPr>
              <p:cNvPr id="50" name="Picture 38" descr="Chart, histogram&#10;&#10;Description automatically generated">
                <a:extLst>
                  <a:ext uri="{FF2B5EF4-FFF2-40B4-BE49-F238E27FC236}">
                    <a16:creationId xmlns:a16="http://schemas.microsoft.com/office/drawing/2014/main" id="{0EDF276C-97E5-4D77-9D3A-3C7D1C4B58D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3421" r="32496" b="50385"/>
              <a:stretch/>
            </p:blipFill>
            <p:spPr>
              <a:xfrm>
                <a:off x="4988500" y="437832"/>
                <a:ext cx="1104099" cy="1215846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988C621C-D2D2-4917-B44C-9A6AFD28C2D5}"/>
                  </a:ext>
                </a:extLst>
              </p:cNvPr>
              <p:cNvSpPr txBox="1"/>
              <p:nvPr/>
            </p:nvSpPr>
            <p:spPr>
              <a:xfrm>
                <a:off x="5437577" y="1609498"/>
                <a:ext cx="52339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100" b="1" dirty="0" err="1"/>
                  <a:t>Fc</a:t>
                </a:r>
                <a:r>
                  <a:rPr lang="en-GB" sz="1100" b="1" dirty="0" err="1">
                    <a:latin typeface="Symbol" panose="05050102010706020507" pitchFamily="18" charset="2"/>
                  </a:rPr>
                  <a:t>e</a:t>
                </a:r>
                <a:r>
                  <a:rPr lang="en-GB" sz="1100" b="1" dirty="0" err="1"/>
                  <a:t>RI</a:t>
                </a:r>
                <a:endParaRPr lang="en-GB" sz="1100" b="1" dirty="0"/>
              </a:p>
            </p:txBody>
          </p:sp>
          <p:sp>
            <p:nvSpPr>
              <p:cNvPr id="69" name="Rectangle 68"/>
              <p:cNvSpPr/>
              <p:nvPr/>
            </p:nvSpPr>
            <p:spPr>
              <a:xfrm>
                <a:off x="4988500" y="469019"/>
                <a:ext cx="1209281" cy="903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5002654" y="1610446"/>
                <a:ext cx="1209281" cy="903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3" name="Rectangle 72"/>
              <p:cNvSpPr/>
              <p:nvPr/>
            </p:nvSpPr>
            <p:spPr>
              <a:xfrm rot="16200000">
                <a:off x="4398014" y="1082797"/>
                <a:ext cx="1209281" cy="903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75" name="Straight Arrow Connector 74">
                <a:extLst>
                  <a:ext uri="{FF2B5EF4-FFF2-40B4-BE49-F238E27FC236}">
                    <a16:creationId xmlns:a16="http://schemas.microsoft.com/office/drawing/2014/main" id="{CA3442D4-06AD-416F-BD7C-2BD2CE05BCEF}"/>
                  </a:ext>
                </a:extLst>
              </p:cNvPr>
              <p:cNvCxnSpPr/>
              <p:nvPr/>
            </p:nvCxnSpPr>
            <p:spPr>
              <a:xfrm>
                <a:off x="5163231" y="1634900"/>
                <a:ext cx="974838" cy="7933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7CC960A0-EFC1-4D7F-B841-A614C37E23C7}"/>
                </a:ext>
              </a:extLst>
            </p:cNvPr>
            <p:cNvSpPr/>
            <p:nvPr/>
          </p:nvSpPr>
          <p:spPr>
            <a:xfrm>
              <a:off x="4767314" y="148219"/>
              <a:ext cx="2117616" cy="306024"/>
            </a:xfrm>
            <a:prstGeom prst="rect">
              <a:avLst/>
            </a:prstGeom>
            <a:noFill/>
            <a:ln w="28575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81" name="Straight Connector 80"/>
            <p:cNvCxnSpPr/>
            <p:nvPr/>
          </p:nvCxnSpPr>
          <p:spPr>
            <a:xfrm flipV="1">
              <a:off x="2342095" y="4958472"/>
              <a:ext cx="268262" cy="2757"/>
            </a:xfrm>
            <a:prstGeom prst="lin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 flipV="1">
              <a:off x="2340276" y="1813345"/>
              <a:ext cx="4544654" cy="7422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/>
            <p:cNvSpPr txBox="1"/>
            <p:nvPr/>
          </p:nvSpPr>
          <p:spPr>
            <a:xfrm>
              <a:off x="3419471" y="4775794"/>
              <a:ext cx="353726" cy="16927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endParaRPr lang="en-GB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5" name="Picture 94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023533" y="553982"/>
              <a:ext cx="676715" cy="512108"/>
            </a:xfrm>
            <a:prstGeom prst="rect">
              <a:avLst/>
            </a:prstGeom>
            <a:solidFill>
              <a:schemeClr val="bg1"/>
            </a:solidFill>
          </p:spPr>
        </p:pic>
        <p:pic>
          <p:nvPicPr>
            <p:cNvPr id="96" name="Picture 95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251827" y="553982"/>
              <a:ext cx="682811" cy="512108"/>
            </a:xfrm>
            <a:prstGeom prst="rect">
              <a:avLst/>
            </a:prstGeom>
          </p:spPr>
        </p:pic>
        <p:sp>
          <p:nvSpPr>
            <p:cNvPr id="98" name="TextBox 97"/>
            <p:cNvSpPr txBox="1"/>
            <p:nvPr/>
          </p:nvSpPr>
          <p:spPr>
            <a:xfrm rot="16200000">
              <a:off x="2726953" y="972822"/>
              <a:ext cx="406611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 rot="16200000">
              <a:off x="4941833" y="970282"/>
              <a:ext cx="406611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FD5E1DE6-B5C9-4C7C-8F7D-14401285DCF2}"/>
                </a:ext>
              </a:extLst>
            </p:cNvPr>
            <p:cNvSpPr/>
            <p:nvPr/>
          </p:nvSpPr>
          <p:spPr>
            <a:xfrm>
              <a:off x="2327854" y="148218"/>
              <a:ext cx="2451445" cy="306025"/>
            </a:xfrm>
            <a:prstGeom prst="rect">
              <a:avLst/>
            </a:prstGeom>
            <a:noFill/>
            <a:ln w="28575"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240304" y="8085231"/>
              <a:ext cx="61473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s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5535825" y="8085231"/>
              <a:ext cx="61473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s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2327854" y="130800"/>
              <a:ext cx="4557076" cy="8244945"/>
            </a:xfrm>
            <a:prstGeom prst="rect">
              <a:avLst/>
            </a:prstGeom>
            <a:noFill/>
            <a:ln w="28575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535825" y="6554156"/>
              <a:ext cx="61473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s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3240304" y="6554156"/>
              <a:ext cx="61473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s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5535825" y="3251187"/>
              <a:ext cx="61473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s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240304" y="3251187"/>
              <a:ext cx="61473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s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535825" y="4740050"/>
              <a:ext cx="61473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s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240304" y="4740050"/>
              <a:ext cx="614734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s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Straight Connector 79"/>
            <p:cNvCxnSpPr/>
            <p:nvPr/>
          </p:nvCxnSpPr>
          <p:spPr>
            <a:xfrm flipV="1">
              <a:off x="2577831" y="4951648"/>
              <a:ext cx="4280169" cy="10931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 rot="16200000">
              <a:off x="4262780" y="2462405"/>
              <a:ext cx="129554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6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xosaminidase</a:t>
              </a:r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lease (%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6200000">
              <a:off x="2088179" y="2462405"/>
              <a:ext cx="129554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6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xosaminidase</a:t>
              </a:r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lease (%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 rot="16200000">
              <a:off x="2079864" y="5792846"/>
              <a:ext cx="129554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6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xosaminidase</a:t>
              </a:r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lease (%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2607952" y="1806776"/>
              <a:ext cx="801" cy="6543923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 rot="16200000">
              <a:off x="4269624" y="5792846"/>
              <a:ext cx="1295547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sz="6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GB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xosaminidase</a:t>
              </a:r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elease (%)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5D1F826-5A35-4663-9651-E5E78EFF9FAB}"/>
                </a:ext>
              </a:extLst>
            </p:cNvPr>
            <p:cNvSpPr txBox="1"/>
            <p:nvPr/>
          </p:nvSpPr>
          <p:spPr>
            <a:xfrm>
              <a:off x="2613097" y="1796954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h</a:t>
              </a:r>
              <a:endParaRPr lang="en-GB" sz="1200" b="1" dirty="0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386E2DC-DBBE-4E42-8A35-DE74447CAB0E}"/>
                </a:ext>
              </a:extLst>
            </p:cNvPr>
            <p:cNvSpPr txBox="1"/>
            <p:nvPr/>
          </p:nvSpPr>
          <p:spPr>
            <a:xfrm>
              <a:off x="4791288" y="1796954"/>
              <a:ext cx="3097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m</a:t>
              </a:r>
              <a:endParaRPr lang="en-GB" sz="1200" b="1" dirty="0"/>
            </a:p>
          </p:txBody>
        </p:sp>
      </p:grpSp>
      <p:pic>
        <p:nvPicPr>
          <p:cNvPr id="44" name="Picture 43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12584" y="5517349"/>
            <a:ext cx="1763571" cy="2890298"/>
          </a:xfrm>
          <a:prstGeom prst="rect">
            <a:avLst/>
          </a:prstGeom>
        </p:spPr>
      </p:pic>
      <p:graphicFrame>
        <p:nvGraphicFramePr>
          <p:cNvPr id="55" name="Object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596584"/>
              </p:ext>
            </p:extLst>
          </p:nvPr>
        </p:nvGraphicFramePr>
        <p:xfrm>
          <a:off x="2541429" y="2260923"/>
          <a:ext cx="1881905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2" name="Graph" r:id="rId16" imgW="3920760" imgH="3000960" progId="Origin95.Graph">
                  <p:embed/>
                </p:oleObj>
              </mc:Choice>
              <mc:Fallback>
                <p:oleObj name="Graph" r:id="rId16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541429" y="2260923"/>
                        <a:ext cx="1881905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c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782305"/>
              </p:ext>
            </p:extLst>
          </p:nvPr>
        </p:nvGraphicFramePr>
        <p:xfrm>
          <a:off x="4885930" y="2262555"/>
          <a:ext cx="1881905" cy="14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3" name="Graph" r:id="rId18" imgW="3920760" imgH="3000960" progId="Origin95.Graph">
                  <p:embed/>
                </p:oleObj>
              </mc:Choice>
              <mc:Fallback>
                <p:oleObj name="Graph" r:id="rId18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885930" y="2262555"/>
                        <a:ext cx="1881905" cy="14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Object 5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053221"/>
              </p:ext>
            </p:extLst>
          </p:nvPr>
        </p:nvGraphicFramePr>
        <p:xfrm>
          <a:off x="4866368" y="3585546"/>
          <a:ext cx="1999525" cy="153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4" name="Graph" r:id="rId20" imgW="3920760" imgH="3000960" progId="Origin95.Graph">
                  <p:embed/>
                </p:oleObj>
              </mc:Choice>
              <mc:Fallback>
                <p:oleObj name="Graph" r:id="rId20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866368" y="3585546"/>
                        <a:ext cx="1999525" cy="153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6" name="Object 7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4466489"/>
              </p:ext>
            </p:extLst>
          </p:nvPr>
        </p:nvGraphicFramePr>
        <p:xfrm>
          <a:off x="2691529" y="3580781"/>
          <a:ext cx="1994085" cy="15258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5" name="Graph" r:id="rId22" imgW="3920760" imgH="3000960" progId="Origin95.Graph">
                  <p:embed/>
                </p:oleObj>
              </mc:Choice>
              <mc:Fallback>
                <p:oleObj name="Graph" r:id="rId22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691529" y="3580781"/>
                        <a:ext cx="1994085" cy="15258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5" name="Object 10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3550067"/>
              </p:ext>
            </p:extLst>
          </p:nvPr>
        </p:nvGraphicFramePr>
        <p:xfrm>
          <a:off x="2693450" y="6970436"/>
          <a:ext cx="1999524" cy="153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6" name="Graph" r:id="rId24" imgW="3920760" imgH="3000960" progId="Origin95.Graph">
                  <p:embed/>
                </p:oleObj>
              </mc:Choice>
              <mc:Fallback>
                <p:oleObj name="Graph" r:id="rId24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2693450" y="6970436"/>
                        <a:ext cx="1999524" cy="153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7" name="Object 10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7867891"/>
              </p:ext>
            </p:extLst>
          </p:nvPr>
        </p:nvGraphicFramePr>
        <p:xfrm>
          <a:off x="4766680" y="7019929"/>
          <a:ext cx="1999523" cy="153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7" name="Graph" r:id="rId26" imgW="3920760" imgH="3000960" progId="Origin95.Graph">
                  <p:embed/>
                </p:oleObj>
              </mc:Choice>
              <mc:Fallback>
                <p:oleObj name="Graph" r:id="rId26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4766680" y="7019929"/>
                        <a:ext cx="1999523" cy="153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9" name="TextBox 108"/>
          <p:cNvSpPr txBox="1"/>
          <p:nvPr/>
        </p:nvSpPr>
        <p:spPr>
          <a:xfrm rot="16200000">
            <a:off x="4339033" y="4284578"/>
            <a:ext cx="973343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amine release (%)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 rot="16200000">
            <a:off x="2154226" y="7623422"/>
            <a:ext cx="973343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amine release (%)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 rot="16200000">
            <a:off x="4353498" y="7623422"/>
            <a:ext cx="973343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stamine release (%)</a:t>
            </a:r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3" name="Object 10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1831495"/>
              </p:ext>
            </p:extLst>
          </p:nvPr>
        </p:nvGraphicFramePr>
        <p:xfrm>
          <a:off x="2751423" y="5489851"/>
          <a:ext cx="1999523" cy="153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8" name="Graph" r:id="rId28" imgW="3920760" imgH="3000960" progId="Origin95.Graph">
                  <p:embed/>
                </p:oleObj>
              </mc:Choice>
              <mc:Fallback>
                <p:oleObj name="Graph" r:id="rId28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2751423" y="5489851"/>
                        <a:ext cx="1999523" cy="153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4" name="Object 10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7668243"/>
              </p:ext>
            </p:extLst>
          </p:nvPr>
        </p:nvGraphicFramePr>
        <p:xfrm>
          <a:off x="4748192" y="5542575"/>
          <a:ext cx="1999525" cy="153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9" name="Graph" r:id="rId30" imgW="3920760" imgH="3000960" progId="Origin95.Graph">
                  <p:embed/>
                </p:oleObj>
              </mc:Choice>
              <mc:Fallback>
                <p:oleObj name="Graph" r:id="rId30" imgW="3920760" imgH="30009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4748192" y="5542575"/>
                        <a:ext cx="1999525" cy="153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5" name="TextBox 114">
            <a:extLst>
              <a:ext uri="{FF2B5EF4-FFF2-40B4-BE49-F238E27FC236}">
                <a16:creationId xmlns:a16="http://schemas.microsoft.com/office/drawing/2014/main" id="{C8622D86-A4DA-45F9-9F6E-6D55E8BB0D6E}"/>
              </a:ext>
            </a:extLst>
          </p:cNvPr>
          <p:cNvSpPr txBox="1"/>
          <p:nvPr/>
        </p:nvSpPr>
        <p:spPr>
          <a:xfrm>
            <a:off x="143271" y="536989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e</a:t>
            </a:r>
            <a:endParaRPr lang="en-GB" sz="1200" b="1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C8622D86-A4DA-45F9-9F6E-6D55E8BB0D6E}"/>
              </a:ext>
            </a:extLst>
          </p:cNvPr>
          <p:cNvSpPr txBox="1"/>
          <p:nvPr/>
        </p:nvSpPr>
        <p:spPr>
          <a:xfrm>
            <a:off x="147689" y="6478663"/>
            <a:ext cx="2327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f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4099387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505EC6A873D5C45A5A6346A6FDC1C5B" ma:contentTypeVersion="16" ma:contentTypeDescription="Create a new document." ma:contentTypeScope="" ma:versionID="e8379eedac7efbc6cfa498ba0d852d97">
  <xsd:schema xmlns:xsd="http://www.w3.org/2001/XMLSchema" xmlns:xs="http://www.w3.org/2001/XMLSchema" xmlns:p="http://schemas.microsoft.com/office/2006/metadata/properties" xmlns:ns3="5c64277e-91b1-45ca-8ce8-6f5adf7f4f13" xmlns:ns4="87ecc899-abf5-4945-8dd9-4e4d0b1a8193" targetNamespace="http://schemas.microsoft.com/office/2006/metadata/properties" ma:root="true" ma:fieldsID="10089debba5d95d3828384dbfb49a840" ns3:_="" ns4:_="">
    <xsd:import namespace="5c64277e-91b1-45ca-8ce8-6f5adf7f4f13"/>
    <xsd:import namespace="87ecc899-abf5-4945-8dd9-4e4d0b1a819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Location" minOccurs="0"/>
                <xsd:element ref="ns4:MediaServiceAutoKeyPoints" minOccurs="0"/>
                <xsd:element ref="ns4:MediaServiceKeyPoints" minOccurs="0"/>
                <xsd:element ref="ns4:MediaServiceGenerationTime" minOccurs="0"/>
                <xsd:element ref="ns4:MediaServiceEventHashCode" minOccurs="0"/>
                <xsd:element ref="ns4:MediaLengthInSeconds" minOccurs="0"/>
                <xsd:element ref="ns4:_activity" minOccurs="0"/>
                <xsd:element ref="ns4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c64277e-91b1-45ca-8ce8-6f5adf7f4f13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7ecc899-abf5-4945-8dd9-4e4d0b1a819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6" nillable="true" ma:displayName="MediaServiceLocation" ma:internalName="MediaServiceLocation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7ecc899-abf5-4945-8dd9-4e4d0b1a8193" xsi:nil="true"/>
  </documentManagement>
</p:properties>
</file>

<file path=customXml/itemProps1.xml><?xml version="1.0" encoding="utf-8"?>
<ds:datastoreItem xmlns:ds="http://schemas.openxmlformats.org/officeDocument/2006/customXml" ds:itemID="{2ED2C6FF-0D16-477D-B4E4-118B33D5DD2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2B655E9-B673-4715-9FBF-131419C4B27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c64277e-91b1-45ca-8ce8-6f5adf7f4f13"/>
    <ds:schemaRef ds:uri="87ecc899-abf5-4945-8dd9-4e4d0b1a819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7ED1F15E-AA9D-4AEF-A2F0-AB38BE1A299F}">
  <ds:schemaRefs>
    <ds:schemaRef ds:uri="http://schemas.microsoft.com/office/2006/metadata/properties"/>
    <ds:schemaRef ds:uri="87ecc899-abf5-4945-8dd9-4e4d0b1a8193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5c64277e-91b1-45ca-8ce8-6f5adf7f4f13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30</TotalTime>
  <Words>104</Words>
  <Application>Microsoft Office PowerPoint</Application>
  <PresentationFormat>A4 Paper (210x297 mm)</PresentationFormat>
  <Paragraphs>4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Graph</vt:lpstr>
      <vt:lpstr>Unicode Origin Graph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ia Pedicini</dc:creator>
  <cp:lastModifiedBy>Lynn McKeown</cp:lastModifiedBy>
  <cp:revision>76</cp:revision>
  <dcterms:created xsi:type="dcterms:W3CDTF">2021-10-08T09:52:25Z</dcterms:created>
  <dcterms:modified xsi:type="dcterms:W3CDTF">2023-11-01T23:21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505EC6A873D5C45A5A6346A6FDC1C5B</vt:lpwstr>
  </property>
</Properties>
</file>